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8" r:id="rId2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602"/>
    <p:restoredTop sz="96327"/>
  </p:normalViewPr>
  <p:slideViewPr>
    <p:cSldViewPr snapToGrid="0">
      <p:cViewPr varScale="1">
        <p:scale>
          <a:sx n="80" d="100"/>
          <a:sy n="80" d="100"/>
        </p:scale>
        <p:origin x="334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yakuba/GSE99574_D_yakuba/count_read_paf1c_genes_yakuba_pileup_FigS1B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ananassae/GSE99574_D_ananasseae/count_read_paf1c_genes_ananassae_assembly_pileup_FigS1B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ananassae/GSE99574_D_ananasseae/count_read_paf1c_genes_ananassae_assembly_pileup_FigS1B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yakuba/GSE99574_D_yakuba/count_read_paf1c_genes_yakuba_pileup_FigS1B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ojavensis/GSE99574_D_mojavensis/count_read_paf1c_genes_mojavensis_pileup_FigS1B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taichiro/Documents/Deep_seq/D_mojavensis/GSE99574_D_mojavensis/count_read_paf1c_genes_mojavensis_pileup_FigS1B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A$3</c:f>
              <c:strCache>
                <c:ptCount val="1"/>
                <c:pt idx="0">
                  <c:v>Ctr9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3:$R$3</c:f>
                <c:numCache>
                  <c:formatCode>General</c:formatCode>
                  <c:ptCount val="8"/>
                  <c:pt idx="0">
                    <c:v>2.3795679185036485</c:v>
                  </c:pt>
                  <c:pt idx="1">
                    <c:v>1.3451459844889011</c:v>
                  </c:pt>
                  <c:pt idx="2">
                    <c:v>2.2478827312864285</c:v>
                  </c:pt>
                  <c:pt idx="3">
                    <c:v>1.8172303358330248</c:v>
                  </c:pt>
                  <c:pt idx="4">
                    <c:v>5.7713520035345098</c:v>
                  </c:pt>
                  <c:pt idx="5">
                    <c:v>0.31435556720573155</c:v>
                  </c:pt>
                  <c:pt idx="6">
                    <c:v>1.8313294731637639</c:v>
                  </c:pt>
                  <c:pt idx="7">
                    <c:v>1.7512472308265754</c:v>
                  </c:pt>
                </c:numCache>
              </c:numRef>
            </c:plus>
            <c:minus>
              <c:numRef>
                <c:f>summary!$K$3:$R$3</c:f>
                <c:numCache>
                  <c:formatCode>General</c:formatCode>
                  <c:ptCount val="8"/>
                  <c:pt idx="0">
                    <c:v>2.3795679185036485</c:v>
                  </c:pt>
                  <c:pt idx="1">
                    <c:v>1.3451459844889011</c:v>
                  </c:pt>
                  <c:pt idx="2">
                    <c:v>2.2478827312864285</c:v>
                  </c:pt>
                  <c:pt idx="3">
                    <c:v>1.8172303358330248</c:v>
                  </c:pt>
                  <c:pt idx="4">
                    <c:v>5.7713520035345098</c:v>
                  </c:pt>
                  <c:pt idx="5">
                    <c:v>0.31435556720573155</c:v>
                  </c:pt>
                  <c:pt idx="6">
                    <c:v>1.8313294731637639</c:v>
                  </c:pt>
                  <c:pt idx="7">
                    <c:v>1.751247230826575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3:$I$3</c:f>
              <c:numCache>
                <c:formatCode>General</c:formatCode>
                <c:ptCount val="8"/>
                <c:pt idx="0">
                  <c:v>72.469946610581431</c:v>
                </c:pt>
                <c:pt idx="1">
                  <c:v>20.854828073011035</c:v>
                </c:pt>
                <c:pt idx="2">
                  <c:v>12.851643578623387</c:v>
                </c:pt>
                <c:pt idx="3">
                  <c:v>9.3301161403649537</c:v>
                </c:pt>
                <c:pt idx="4">
                  <c:v>41.817827006360801</c:v>
                </c:pt>
                <c:pt idx="5">
                  <c:v>13.268313279046774</c:v>
                </c:pt>
                <c:pt idx="6">
                  <c:v>21.561548716675219</c:v>
                </c:pt>
                <c:pt idx="7">
                  <c:v>20.4606459346579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FC-6F40-8DED-52217216D1FA}"/>
            </c:ext>
          </c:extLst>
        </c:ser>
        <c:ser>
          <c:idx val="1"/>
          <c:order val="1"/>
          <c:tx>
            <c:strRef>
              <c:f>summary!$A$4</c:f>
              <c:strCache>
                <c:ptCount val="1"/>
                <c:pt idx="0">
                  <c:v>Paf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4:$R$4</c:f>
                <c:numCache>
                  <c:formatCode>General</c:formatCode>
                  <c:ptCount val="8"/>
                  <c:pt idx="0">
                    <c:v>4.360017530296119</c:v>
                  </c:pt>
                  <c:pt idx="1">
                    <c:v>2.9103589195265558</c:v>
                  </c:pt>
                  <c:pt idx="2">
                    <c:v>2.1932654378769363</c:v>
                  </c:pt>
                  <c:pt idx="3">
                    <c:v>1.8256513270190207</c:v>
                  </c:pt>
                  <c:pt idx="4">
                    <c:v>1.1817713571367492</c:v>
                  </c:pt>
                  <c:pt idx="5">
                    <c:v>0.28330156785730565</c:v>
                  </c:pt>
                  <c:pt idx="6">
                    <c:v>1.3236330528673634</c:v>
                  </c:pt>
                  <c:pt idx="7">
                    <c:v>0.71653730126395099</c:v>
                  </c:pt>
                </c:numCache>
              </c:numRef>
            </c:plus>
            <c:minus>
              <c:numRef>
                <c:f>summary!$K$4:$R$4</c:f>
                <c:numCache>
                  <c:formatCode>General</c:formatCode>
                  <c:ptCount val="8"/>
                  <c:pt idx="0">
                    <c:v>4.360017530296119</c:v>
                  </c:pt>
                  <c:pt idx="1">
                    <c:v>2.9103589195265558</c:v>
                  </c:pt>
                  <c:pt idx="2">
                    <c:v>2.1932654378769363</c:v>
                  </c:pt>
                  <c:pt idx="3">
                    <c:v>1.8256513270190207</c:v>
                  </c:pt>
                  <c:pt idx="4">
                    <c:v>1.1817713571367492</c:v>
                  </c:pt>
                  <c:pt idx="5">
                    <c:v>0.28330156785730565</c:v>
                  </c:pt>
                  <c:pt idx="6">
                    <c:v>1.3236330528673634</c:v>
                  </c:pt>
                  <c:pt idx="7">
                    <c:v>0.716537301263950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4:$I$4</c:f>
              <c:numCache>
                <c:formatCode>General</c:formatCode>
                <c:ptCount val="8"/>
                <c:pt idx="0">
                  <c:v>70.272995306374256</c:v>
                </c:pt>
                <c:pt idx="1">
                  <c:v>16.562256926244476</c:v>
                </c:pt>
                <c:pt idx="2">
                  <c:v>9.9449825340092826</c:v>
                </c:pt>
                <c:pt idx="3">
                  <c:v>11.33916360845061</c:v>
                </c:pt>
                <c:pt idx="4">
                  <c:v>18.19057665806972</c:v>
                </c:pt>
                <c:pt idx="5">
                  <c:v>12.847057010853623</c:v>
                </c:pt>
                <c:pt idx="6">
                  <c:v>18.037332415495353</c:v>
                </c:pt>
                <c:pt idx="7">
                  <c:v>14.7850719703910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FC-6F40-8DED-52217216D1FA}"/>
            </c:ext>
          </c:extLst>
        </c:ser>
        <c:ser>
          <c:idx val="2"/>
          <c:order val="2"/>
          <c:tx>
            <c:strRef>
              <c:f>summary!$A$5</c:f>
              <c:strCache>
                <c:ptCount val="1"/>
                <c:pt idx="0">
                  <c:v>Leo1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5:$R$5</c:f>
                <c:numCache>
                  <c:formatCode>General</c:formatCode>
                  <c:ptCount val="8"/>
                  <c:pt idx="0">
                    <c:v>0.60168656835699297</c:v>
                  </c:pt>
                  <c:pt idx="1">
                    <c:v>0.98942615854354399</c:v>
                  </c:pt>
                  <c:pt idx="2">
                    <c:v>0.33834650638373248</c:v>
                  </c:pt>
                  <c:pt idx="3">
                    <c:v>0.46477551216901319</c:v>
                  </c:pt>
                  <c:pt idx="4">
                    <c:v>1.232321857405831</c:v>
                  </c:pt>
                  <c:pt idx="5">
                    <c:v>0.47386231495942338</c:v>
                  </c:pt>
                  <c:pt idx="6">
                    <c:v>0.87814140372212868</c:v>
                  </c:pt>
                  <c:pt idx="7">
                    <c:v>0.25244963172135937</c:v>
                  </c:pt>
                </c:numCache>
              </c:numRef>
            </c:plus>
            <c:minus>
              <c:numRef>
                <c:f>summary!$K$5:$R$5</c:f>
                <c:numCache>
                  <c:formatCode>General</c:formatCode>
                  <c:ptCount val="8"/>
                  <c:pt idx="0">
                    <c:v>0.60168656835699297</c:v>
                  </c:pt>
                  <c:pt idx="1">
                    <c:v>0.98942615854354399</c:v>
                  </c:pt>
                  <c:pt idx="2">
                    <c:v>0.33834650638373248</c:v>
                  </c:pt>
                  <c:pt idx="3">
                    <c:v>0.46477551216901319</c:v>
                  </c:pt>
                  <c:pt idx="4">
                    <c:v>1.232321857405831</c:v>
                  </c:pt>
                  <c:pt idx="5">
                    <c:v>0.47386231495942338</c:v>
                  </c:pt>
                  <c:pt idx="6">
                    <c:v>0.87814140372212868</c:v>
                  </c:pt>
                  <c:pt idx="7">
                    <c:v>0.252449631721359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5:$I$5</c:f>
              <c:numCache>
                <c:formatCode>General</c:formatCode>
                <c:ptCount val="8"/>
                <c:pt idx="0">
                  <c:v>55.67342615591388</c:v>
                </c:pt>
                <c:pt idx="1">
                  <c:v>17.788979720765955</c:v>
                </c:pt>
                <c:pt idx="2">
                  <c:v>5.7325275421820763</c:v>
                </c:pt>
                <c:pt idx="3">
                  <c:v>6.9587753077279828</c:v>
                </c:pt>
                <c:pt idx="4">
                  <c:v>10.391095899301341</c:v>
                </c:pt>
                <c:pt idx="5">
                  <c:v>5.5733695382225976</c:v>
                </c:pt>
                <c:pt idx="6">
                  <c:v>8.6194041531208807</c:v>
                </c:pt>
                <c:pt idx="7">
                  <c:v>8.78140910891719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5FC-6F40-8DED-52217216D1FA}"/>
            </c:ext>
          </c:extLst>
        </c:ser>
        <c:ser>
          <c:idx val="3"/>
          <c:order val="3"/>
          <c:tx>
            <c:strRef>
              <c:f>summary!$A$6</c:f>
              <c:strCache>
                <c:ptCount val="1"/>
                <c:pt idx="0">
                  <c:v>Cdc73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6:$R$6</c:f>
                <c:numCache>
                  <c:formatCode>General</c:formatCode>
                  <c:ptCount val="8"/>
                  <c:pt idx="0">
                    <c:v>5.3728673274104271</c:v>
                  </c:pt>
                  <c:pt idx="1">
                    <c:v>1.9568400859844097</c:v>
                  </c:pt>
                  <c:pt idx="2">
                    <c:v>2.215181564957883</c:v>
                  </c:pt>
                  <c:pt idx="3">
                    <c:v>1.7562642499740904</c:v>
                  </c:pt>
                  <c:pt idx="4">
                    <c:v>2.0606165914963048</c:v>
                  </c:pt>
                  <c:pt idx="5">
                    <c:v>0.75098791622257977</c:v>
                  </c:pt>
                  <c:pt idx="6">
                    <c:v>2.3867016749328709</c:v>
                  </c:pt>
                  <c:pt idx="7">
                    <c:v>1.9255808381783459</c:v>
                  </c:pt>
                </c:numCache>
              </c:numRef>
            </c:plus>
            <c:minus>
              <c:numRef>
                <c:f>summary!$K$6:$R$6</c:f>
                <c:numCache>
                  <c:formatCode>General</c:formatCode>
                  <c:ptCount val="8"/>
                  <c:pt idx="0">
                    <c:v>5.3728673274104271</c:v>
                  </c:pt>
                  <c:pt idx="1">
                    <c:v>1.9568400859844097</c:v>
                  </c:pt>
                  <c:pt idx="2">
                    <c:v>2.215181564957883</c:v>
                  </c:pt>
                  <c:pt idx="3">
                    <c:v>1.7562642499740904</c:v>
                  </c:pt>
                  <c:pt idx="4">
                    <c:v>2.0606165914963048</c:v>
                  </c:pt>
                  <c:pt idx="5">
                    <c:v>0.75098791622257977</c:v>
                  </c:pt>
                  <c:pt idx="6">
                    <c:v>2.3867016749328709</c:v>
                  </c:pt>
                  <c:pt idx="7">
                    <c:v>1.925580838178345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6:$I$6</c:f>
              <c:numCache>
                <c:formatCode>General</c:formatCode>
                <c:ptCount val="8"/>
                <c:pt idx="0">
                  <c:v>69.263148486032534</c:v>
                </c:pt>
                <c:pt idx="1">
                  <c:v>21.124440940223156</c:v>
                </c:pt>
                <c:pt idx="2">
                  <c:v>60.303373674211493</c:v>
                </c:pt>
                <c:pt idx="3">
                  <c:v>9.9811872938628898</c:v>
                </c:pt>
                <c:pt idx="4">
                  <c:v>26.103509741353033</c:v>
                </c:pt>
                <c:pt idx="5">
                  <c:v>11.485422633664408</c:v>
                </c:pt>
                <c:pt idx="6">
                  <c:v>23.36365220564673</c:v>
                </c:pt>
                <c:pt idx="7">
                  <c:v>29.2992520210186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5FC-6F40-8DED-52217216D1FA}"/>
            </c:ext>
          </c:extLst>
        </c:ser>
        <c:ser>
          <c:idx val="4"/>
          <c:order val="4"/>
          <c:tx>
            <c:strRef>
              <c:f>summary!$A$7</c:f>
              <c:strCache>
                <c:ptCount val="1"/>
                <c:pt idx="0">
                  <c:v>Rtf1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7:$R$7</c:f>
                <c:numCache>
                  <c:formatCode>General</c:formatCode>
                  <c:ptCount val="8"/>
                  <c:pt idx="0">
                    <c:v>6.5662730752765857</c:v>
                  </c:pt>
                  <c:pt idx="1">
                    <c:v>1.3402434163903927</c:v>
                  </c:pt>
                  <c:pt idx="2">
                    <c:v>0.54656988770917969</c:v>
                  </c:pt>
                  <c:pt idx="3">
                    <c:v>0.91230924117885381</c:v>
                  </c:pt>
                  <c:pt idx="4">
                    <c:v>2.3143593776451175</c:v>
                  </c:pt>
                  <c:pt idx="5">
                    <c:v>0.63372243935073258</c:v>
                  </c:pt>
                  <c:pt idx="6">
                    <c:v>1.3698374160307936</c:v>
                  </c:pt>
                  <c:pt idx="7">
                    <c:v>0.45512705506140005</c:v>
                  </c:pt>
                </c:numCache>
              </c:numRef>
            </c:plus>
            <c:minus>
              <c:numRef>
                <c:f>summary!$K$7:$R$7</c:f>
                <c:numCache>
                  <c:formatCode>General</c:formatCode>
                  <c:ptCount val="8"/>
                  <c:pt idx="0">
                    <c:v>6.5662730752765857</c:v>
                  </c:pt>
                  <c:pt idx="1">
                    <c:v>1.3402434163903927</c:v>
                  </c:pt>
                  <c:pt idx="2">
                    <c:v>0.54656988770917969</c:v>
                  </c:pt>
                  <c:pt idx="3">
                    <c:v>0.91230924117885381</c:v>
                  </c:pt>
                  <c:pt idx="4">
                    <c:v>2.3143593776451175</c:v>
                  </c:pt>
                  <c:pt idx="5">
                    <c:v>0.63372243935073258</c:v>
                  </c:pt>
                  <c:pt idx="6">
                    <c:v>1.3698374160307936</c:v>
                  </c:pt>
                  <c:pt idx="7">
                    <c:v>0.455127055061400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7:$I$7</c:f>
              <c:numCache>
                <c:formatCode>General</c:formatCode>
                <c:ptCount val="8"/>
                <c:pt idx="0">
                  <c:v>73.58926205234205</c:v>
                </c:pt>
                <c:pt idx="1">
                  <c:v>16.683742911108371</c:v>
                </c:pt>
                <c:pt idx="2">
                  <c:v>6.5031439830204327</c:v>
                </c:pt>
                <c:pt idx="3">
                  <c:v>10.38087690092315</c:v>
                </c:pt>
                <c:pt idx="4">
                  <c:v>31.127484255269383</c:v>
                </c:pt>
                <c:pt idx="5">
                  <c:v>10.594793492534068</c:v>
                </c:pt>
                <c:pt idx="6">
                  <c:v>24.474465036705329</c:v>
                </c:pt>
                <c:pt idx="7">
                  <c:v>16.014418063558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5FC-6F40-8DED-52217216D1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9990768"/>
        <c:axId val="399992768"/>
      </c:barChart>
      <c:catAx>
        <c:axId val="399990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2768"/>
        <c:crosses val="autoZero"/>
        <c:auto val="1"/>
        <c:lblAlgn val="ctr"/>
        <c:lblOffset val="100"/>
        <c:noMultiLvlLbl val="0"/>
      </c:catAx>
      <c:valAx>
        <c:axId val="39999276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076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8017935258092741"/>
          <c:y val="6.7586206896551718E-2"/>
          <c:w val="0.16417796733741619"/>
          <c:h val="0.312767317128837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en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A$3</c:f>
              <c:strCache>
                <c:ptCount val="1"/>
                <c:pt idx="0">
                  <c:v>Ctr9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3:$R$3</c:f>
                <c:numCache>
                  <c:formatCode>General</c:formatCode>
                  <c:ptCount val="8"/>
                  <c:pt idx="0">
                    <c:v>3.2476033372817943</c:v>
                  </c:pt>
                  <c:pt idx="1">
                    <c:v>1.4449076944431212</c:v>
                  </c:pt>
                  <c:pt idx="2">
                    <c:v>1.2311270018223646</c:v>
                  </c:pt>
                  <c:pt idx="3">
                    <c:v>2.2161226169178625</c:v>
                  </c:pt>
                  <c:pt idx="4">
                    <c:v>1.2149601275109099</c:v>
                  </c:pt>
                  <c:pt idx="5">
                    <c:v>8.2952922186100148E-2</c:v>
                  </c:pt>
                  <c:pt idx="6">
                    <c:v>1.5855201095298557</c:v>
                  </c:pt>
                  <c:pt idx="7">
                    <c:v>1.9203561146241273</c:v>
                  </c:pt>
                </c:numCache>
              </c:numRef>
            </c:plus>
            <c:minus>
              <c:numRef>
                <c:f>summary!$K$3:$R$3</c:f>
                <c:numCache>
                  <c:formatCode>General</c:formatCode>
                  <c:ptCount val="8"/>
                  <c:pt idx="0">
                    <c:v>3.2476033372817943</c:v>
                  </c:pt>
                  <c:pt idx="1">
                    <c:v>1.4449076944431212</c:v>
                  </c:pt>
                  <c:pt idx="2">
                    <c:v>1.2311270018223646</c:v>
                  </c:pt>
                  <c:pt idx="3">
                    <c:v>2.2161226169178625</c:v>
                  </c:pt>
                  <c:pt idx="4">
                    <c:v>1.2149601275109099</c:v>
                  </c:pt>
                  <c:pt idx="5">
                    <c:v>8.2952922186100148E-2</c:v>
                  </c:pt>
                  <c:pt idx="6">
                    <c:v>1.5855201095298557</c:v>
                  </c:pt>
                  <c:pt idx="7">
                    <c:v>1.92035611462412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3:$I$3</c:f>
              <c:numCache>
                <c:formatCode>General</c:formatCode>
                <c:ptCount val="8"/>
                <c:pt idx="0">
                  <c:v>79.793855393723234</c:v>
                </c:pt>
                <c:pt idx="1">
                  <c:v>31.537200185825828</c:v>
                </c:pt>
                <c:pt idx="2">
                  <c:v>8.4805448509716825</c:v>
                </c:pt>
                <c:pt idx="3">
                  <c:v>13.912955484130704</c:v>
                </c:pt>
                <c:pt idx="4">
                  <c:v>18.619875195633998</c:v>
                </c:pt>
                <c:pt idx="5">
                  <c:v>10.459656454741971</c:v>
                </c:pt>
                <c:pt idx="6">
                  <c:v>20.478085670638418</c:v>
                </c:pt>
                <c:pt idx="7">
                  <c:v>17.6660434498740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82-C74A-BB13-6B38AC7CBAD7}"/>
            </c:ext>
          </c:extLst>
        </c:ser>
        <c:ser>
          <c:idx val="1"/>
          <c:order val="1"/>
          <c:tx>
            <c:strRef>
              <c:f>summary!$A$4</c:f>
              <c:strCache>
                <c:ptCount val="1"/>
                <c:pt idx="0">
                  <c:v>Paf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4:$R$4</c:f>
                <c:numCache>
                  <c:formatCode>General</c:formatCode>
                  <c:ptCount val="8"/>
                  <c:pt idx="0">
                    <c:v>0.29866803463381925</c:v>
                  </c:pt>
                  <c:pt idx="1">
                    <c:v>1.4379234887231063</c:v>
                  </c:pt>
                  <c:pt idx="2">
                    <c:v>6.5799905735797246</c:v>
                  </c:pt>
                  <c:pt idx="3">
                    <c:v>0.85092910221039419</c:v>
                  </c:pt>
                  <c:pt idx="4">
                    <c:v>2.8924758738046745</c:v>
                  </c:pt>
                  <c:pt idx="5">
                    <c:v>1.0269279473711694</c:v>
                  </c:pt>
                  <c:pt idx="6">
                    <c:v>1.8124652596599791</c:v>
                  </c:pt>
                  <c:pt idx="7">
                    <c:v>0.92175454085284081</c:v>
                  </c:pt>
                </c:numCache>
              </c:numRef>
            </c:plus>
            <c:minus>
              <c:numRef>
                <c:f>summary!$K$4:$R$4</c:f>
                <c:numCache>
                  <c:formatCode>General</c:formatCode>
                  <c:ptCount val="8"/>
                  <c:pt idx="0">
                    <c:v>0.29866803463381925</c:v>
                  </c:pt>
                  <c:pt idx="1">
                    <c:v>1.4379234887231063</c:v>
                  </c:pt>
                  <c:pt idx="2">
                    <c:v>6.5799905735797246</c:v>
                  </c:pt>
                  <c:pt idx="3">
                    <c:v>0.85092910221039419</c:v>
                  </c:pt>
                  <c:pt idx="4">
                    <c:v>2.8924758738046745</c:v>
                  </c:pt>
                  <c:pt idx="5">
                    <c:v>1.0269279473711694</c:v>
                  </c:pt>
                  <c:pt idx="6">
                    <c:v>1.8124652596599791</c:v>
                  </c:pt>
                  <c:pt idx="7">
                    <c:v>0.921754540852840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4:$I$4</c:f>
              <c:numCache>
                <c:formatCode>General</c:formatCode>
                <c:ptCount val="8"/>
                <c:pt idx="0">
                  <c:v>57.589102336041357</c:v>
                </c:pt>
                <c:pt idx="1">
                  <c:v>19.711090371365668</c:v>
                </c:pt>
                <c:pt idx="2">
                  <c:v>26.046313149027309</c:v>
                </c:pt>
                <c:pt idx="3">
                  <c:v>11.328511076183384</c:v>
                </c:pt>
                <c:pt idx="4">
                  <c:v>15.028458091225682</c:v>
                </c:pt>
                <c:pt idx="5">
                  <c:v>9.1311260734846105</c:v>
                </c:pt>
                <c:pt idx="6">
                  <c:v>14.367206602583957</c:v>
                </c:pt>
                <c:pt idx="7">
                  <c:v>13.2714788544392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82-C74A-BB13-6B38AC7CBAD7}"/>
            </c:ext>
          </c:extLst>
        </c:ser>
        <c:ser>
          <c:idx val="2"/>
          <c:order val="2"/>
          <c:tx>
            <c:strRef>
              <c:f>summary!$A$5</c:f>
              <c:strCache>
                <c:ptCount val="1"/>
                <c:pt idx="0">
                  <c:v>Leo1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5:$R$5</c:f>
                <c:numCache>
                  <c:formatCode>General</c:formatCode>
                  <c:ptCount val="8"/>
                  <c:pt idx="0">
                    <c:v>4.3113012377404329</c:v>
                  </c:pt>
                  <c:pt idx="1">
                    <c:v>3.0703226473407814</c:v>
                  </c:pt>
                  <c:pt idx="2">
                    <c:v>0.56631831929204934</c:v>
                  </c:pt>
                  <c:pt idx="3">
                    <c:v>0.90749567331902892</c:v>
                  </c:pt>
                  <c:pt idx="4">
                    <c:v>5.1383847332103478</c:v>
                  </c:pt>
                  <c:pt idx="5">
                    <c:v>1.2169493874334532</c:v>
                  </c:pt>
                  <c:pt idx="6">
                    <c:v>2.798876361290402</c:v>
                  </c:pt>
                  <c:pt idx="7">
                    <c:v>1.9798444541086981</c:v>
                  </c:pt>
                </c:numCache>
              </c:numRef>
            </c:plus>
            <c:minus>
              <c:numRef>
                <c:f>summary!$K$5:$R$5</c:f>
                <c:numCache>
                  <c:formatCode>General</c:formatCode>
                  <c:ptCount val="8"/>
                  <c:pt idx="0">
                    <c:v>4.3113012377404329</c:v>
                  </c:pt>
                  <c:pt idx="1">
                    <c:v>3.0703226473407814</c:v>
                  </c:pt>
                  <c:pt idx="2">
                    <c:v>0.56631831929204934</c:v>
                  </c:pt>
                  <c:pt idx="3">
                    <c:v>0.90749567331902892</c:v>
                  </c:pt>
                  <c:pt idx="4">
                    <c:v>5.1383847332103478</c:v>
                  </c:pt>
                  <c:pt idx="5">
                    <c:v>1.2169493874334532</c:v>
                  </c:pt>
                  <c:pt idx="6">
                    <c:v>2.798876361290402</c:v>
                  </c:pt>
                  <c:pt idx="7">
                    <c:v>1.97984445410869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5:$I$5</c:f>
              <c:numCache>
                <c:formatCode>General</c:formatCode>
                <c:ptCount val="8"/>
                <c:pt idx="0">
                  <c:v>58.184510286795899</c:v>
                </c:pt>
                <c:pt idx="1">
                  <c:v>67.536341134035823</c:v>
                </c:pt>
                <c:pt idx="2">
                  <c:v>11.13386588681953</c:v>
                </c:pt>
                <c:pt idx="3">
                  <c:v>15.661523256228669</c:v>
                </c:pt>
                <c:pt idx="4">
                  <c:v>25.36603213365991</c:v>
                </c:pt>
                <c:pt idx="5">
                  <c:v>12.063137721088459</c:v>
                </c:pt>
                <c:pt idx="6">
                  <c:v>18.518620316174758</c:v>
                </c:pt>
                <c:pt idx="7">
                  <c:v>31.6024541935807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082-C74A-BB13-6B38AC7CBAD7}"/>
            </c:ext>
          </c:extLst>
        </c:ser>
        <c:ser>
          <c:idx val="3"/>
          <c:order val="3"/>
          <c:tx>
            <c:strRef>
              <c:f>summary!$A$6</c:f>
              <c:strCache>
                <c:ptCount val="1"/>
                <c:pt idx="0">
                  <c:v>Cdc73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6:$R$6</c:f>
                <c:numCache>
                  <c:formatCode>General</c:formatCode>
                  <c:ptCount val="8"/>
                  <c:pt idx="0">
                    <c:v>0.8650289984606635</c:v>
                  </c:pt>
                  <c:pt idx="1">
                    <c:v>2.2875521567029624</c:v>
                  </c:pt>
                  <c:pt idx="2">
                    <c:v>1.6634928991767444</c:v>
                  </c:pt>
                  <c:pt idx="3">
                    <c:v>2.3927160072061611</c:v>
                  </c:pt>
                  <c:pt idx="4">
                    <c:v>1.2421096554886994</c:v>
                  </c:pt>
                  <c:pt idx="5">
                    <c:v>1.4929848711951033</c:v>
                  </c:pt>
                  <c:pt idx="6">
                    <c:v>0.65394547445735218</c:v>
                  </c:pt>
                  <c:pt idx="7">
                    <c:v>0.61304656553005765</c:v>
                  </c:pt>
                </c:numCache>
              </c:numRef>
            </c:plus>
            <c:minus>
              <c:numRef>
                <c:f>summary!$K$6:$R$6</c:f>
                <c:numCache>
                  <c:formatCode>General</c:formatCode>
                  <c:ptCount val="8"/>
                  <c:pt idx="0">
                    <c:v>0.8650289984606635</c:v>
                  </c:pt>
                  <c:pt idx="1">
                    <c:v>2.2875521567029624</c:v>
                  </c:pt>
                  <c:pt idx="2">
                    <c:v>1.6634928991767444</c:v>
                  </c:pt>
                  <c:pt idx="3">
                    <c:v>2.3927160072061611</c:v>
                  </c:pt>
                  <c:pt idx="4">
                    <c:v>1.2421096554886994</c:v>
                  </c:pt>
                  <c:pt idx="5">
                    <c:v>1.4929848711951033</c:v>
                  </c:pt>
                  <c:pt idx="6">
                    <c:v>0.65394547445735218</c:v>
                  </c:pt>
                  <c:pt idx="7">
                    <c:v>0.613046565530057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6:$I$6</c:f>
              <c:numCache>
                <c:formatCode>General</c:formatCode>
                <c:ptCount val="8"/>
                <c:pt idx="0">
                  <c:v>70.33088168397002</c:v>
                </c:pt>
                <c:pt idx="1">
                  <c:v>22.821372825507922</c:v>
                </c:pt>
                <c:pt idx="2">
                  <c:v>10.152281039434257</c:v>
                </c:pt>
                <c:pt idx="3">
                  <c:v>11.094243512696403</c:v>
                </c:pt>
                <c:pt idx="4">
                  <c:v>16.797354329709993</c:v>
                </c:pt>
                <c:pt idx="5">
                  <c:v>8.9915816611608292</c:v>
                </c:pt>
                <c:pt idx="6">
                  <c:v>18.542612815726908</c:v>
                </c:pt>
                <c:pt idx="7">
                  <c:v>14.8122095611087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082-C74A-BB13-6B38AC7CBAD7}"/>
            </c:ext>
          </c:extLst>
        </c:ser>
        <c:ser>
          <c:idx val="4"/>
          <c:order val="4"/>
          <c:tx>
            <c:strRef>
              <c:f>summary!$A$7</c:f>
              <c:strCache>
                <c:ptCount val="1"/>
                <c:pt idx="0">
                  <c:v>Rtf1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7:$R$7</c:f>
                <c:numCache>
                  <c:formatCode>General</c:formatCode>
                  <c:ptCount val="8"/>
                  <c:pt idx="0">
                    <c:v>12.003858777270393</c:v>
                  </c:pt>
                  <c:pt idx="1">
                    <c:v>2.5856234891847873</c:v>
                  </c:pt>
                  <c:pt idx="2">
                    <c:v>0.66934692761874481</c:v>
                  </c:pt>
                  <c:pt idx="3">
                    <c:v>3.6768274528076335</c:v>
                  </c:pt>
                  <c:pt idx="4">
                    <c:v>4.1777761307560608</c:v>
                  </c:pt>
                  <c:pt idx="5">
                    <c:v>0.80765578910111402</c:v>
                  </c:pt>
                  <c:pt idx="6">
                    <c:v>0.85274896980063031</c:v>
                  </c:pt>
                  <c:pt idx="7">
                    <c:v>1.0521441354233902</c:v>
                  </c:pt>
                </c:numCache>
              </c:numRef>
            </c:plus>
            <c:minus>
              <c:numRef>
                <c:f>summary!$K$7:$R$7</c:f>
                <c:numCache>
                  <c:formatCode>General</c:formatCode>
                  <c:ptCount val="8"/>
                  <c:pt idx="0">
                    <c:v>12.003858777270393</c:v>
                  </c:pt>
                  <c:pt idx="1">
                    <c:v>2.5856234891847873</c:v>
                  </c:pt>
                  <c:pt idx="2">
                    <c:v>0.66934692761874481</c:v>
                  </c:pt>
                  <c:pt idx="3">
                    <c:v>3.6768274528076335</c:v>
                  </c:pt>
                  <c:pt idx="4">
                    <c:v>4.1777761307560608</c:v>
                  </c:pt>
                  <c:pt idx="5">
                    <c:v>0.80765578910111402</c:v>
                  </c:pt>
                  <c:pt idx="6">
                    <c:v>0.85274896980063031</c:v>
                  </c:pt>
                  <c:pt idx="7">
                    <c:v>1.05214413542339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7:$I$7</c:f>
              <c:numCache>
                <c:formatCode>General</c:formatCode>
                <c:ptCount val="8"/>
                <c:pt idx="0">
                  <c:v>83.871928135376663</c:v>
                </c:pt>
                <c:pt idx="1">
                  <c:v>34.8210155816382</c:v>
                </c:pt>
                <c:pt idx="2">
                  <c:v>14.106637715747738</c:v>
                </c:pt>
                <c:pt idx="3">
                  <c:v>25.975186436737783</c:v>
                </c:pt>
                <c:pt idx="4">
                  <c:v>38.795963538790424</c:v>
                </c:pt>
                <c:pt idx="5">
                  <c:v>18.878858362993245</c:v>
                </c:pt>
                <c:pt idx="6">
                  <c:v>39.751151253007009</c:v>
                </c:pt>
                <c:pt idx="7">
                  <c:v>25.7651923092138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082-C74A-BB13-6B38AC7CBA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9990768"/>
        <c:axId val="399992768"/>
      </c:barChart>
      <c:catAx>
        <c:axId val="399990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2768"/>
        <c:crosses val="autoZero"/>
        <c:auto val="1"/>
        <c:lblAlgn val="ctr"/>
        <c:lblOffset val="100"/>
        <c:noMultiLvlLbl val="0"/>
      </c:catAx>
      <c:valAx>
        <c:axId val="39999276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076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8017935258092741"/>
          <c:y val="6.7586206896551718E-2"/>
          <c:w val="0.16417796733741619"/>
          <c:h val="0.312767317128837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en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A$9</c:f>
              <c:strCache>
                <c:ptCount val="1"/>
                <c:pt idx="0">
                  <c:v>Ctr9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9:$R$9</c:f>
                <c:numCache>
                  <c:formatCode>General</c:formatCode>
                  <c:ptCount val="8"/>
                  <c:pt idx="0">
                    <c:v>3.6715483399939804E-2</c:v>
                  </c:pt>
                  <c:pt idx="1">
                    <c:v>0.64161644099978443</c:v>
                  </c:pt>
                  <c:pt idx="2">
                    <c:v>0</c:v>
                  </c:pt>
                  <c:pt idx="3">
                    <c:v>0</c:v>
                  </c:pt>
                  <c:pt idx="4">
                    <c:v>0.85025350853144543</c:v>
                  </c:pt>
                  <c:pt idx="5">
                    <c:v>0</c:v>
                  </c:pt>
                  <c:pt idx="6">
                    <c:v>0</c:v>
                  </c:pt>
                  <c:pt idx="7">
                    <c:v>0.40329856074317527</c:v>
                  </c:pt>
                </c:numCache>
              </c:numRef>
            </c:plus>
            <c:minus>
              <c:numRef>
                <c:f>summary!$K$9:$R$9</c:f>
                <c:numCache>
                  <c:formatCode>General</c:formatCode>
                  <c:ptCount val="8"/>
                  <c:pt idx="0">
                    <c:v>3.6715483399939804E-2</c:v>
                  </c:pt>
                  <c:pt idx="1">
                    <c:v>0.64161644099978443</c:v>
                  </c:pt>
                  <c:pt idx="2">
                    <c:v>0</c:v>
                  </c:pt>
                  <c:pt idx="3">
                    <c:v>0</c:v>
                  </c:pt>
                  <c:pt idx="4">
                    <c:v>0.85025350853144543</c:v>
                  </c:pt>
                  <c:pt idx="5">
                    <c:v>0</c:v>
                  </c:pt>
                  <c:pt idx="6">
                    <c:v>0</c:v>
                  </c:pt>
                  <c:pt idx="7">
                    <c:v>0.403298560743175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9:$I$9</c:f>
              <c:numCache>
                <c:formatCode>General</c:formatCode>
                <c:ptCount val="8"/>
                <c:pt idx="0">
                  <c:v>2.5961767286639553E-2</c:v>
                </c:pt>
                <c:pt idx="1">
                  <c:v>5.2797519131795836</c:v>
                </c:pt>
                <c:pt idx="2">
                  <c:v>0</c:v>
                </c:pt>
                <c:pt idx="3">
                  <c:v>0</c:v>
                </c:pt>
                <c:pt idx="4">
                  <c:v>0.67171186904455427</c:v>
                </c:pt>
                <c:pt idx="5">
                  <c:v>0</c:v>
                </c:pt>
                <c:pt idx="6">
                  <c:v>0</c:v>
                </c:pt>
                <c:pt idx="7">
                  <c:v>1.47859024877841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95E-3A45-B52D-F1F9E9074FC7}"/>
            </c:ext>
          </c:extLst>
        </c:ser>
        <c:ser>
          <c:idx val="1"/>
          <c:order val="1"/>
          <c:tx>
            <c:strRef>
              <c:f>summary!$A$10</c:f>
              <c:strCache>
                <c:ptCount val="1"/>
                <c:pt idx="0">
                  <c:v>Paf1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0:$R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9532206250844855</c:v>
                  </c:pt>
                  <c:pt idx="2">
                    <c:v>0.16799374251887828</c:v>
                  </c:pt>
                  <c:pt idx="3">
                    <c:v>0</c:v>
                  </c:pt>
                  <c:pt idx="4">
                    <c:v>2.1890934880124613</c:v>
                  </c:pt>
                  <c:pt idx="5">
                    <c:v>0</c:v>
                  </c:pt>
                  <c:pt idx="6">
                    <c:v>0</c:v>
                  </c:pt>
                  <c:pt idx="7">
                    <c:v>0.85078843943175286</c:v>
                  </c:pt>
                </c:numCache>
              </c:numRef>
            </c:plus>
            <c:minus>
              <c:numRef>
                <c:f>summary!$K$10:$R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2.9532206250844855</c:v>
                  </c:pt>
                  <c:pt idx="2">
                    <c:v>0.16799374251887828</c:v>
                  </c:pt>
                  <c:pt idx="3">
                    <c:v>0</c:v>
                  </c:pt>
                  <c:pt idx="4">
                    <c:v>2.1890934880124613</c:v>
                  </c:pt>
                  <c:pt idx="5">
                    <c:v>0</c:v>
                  </c:pt>
                  <c:pt idx="6">
                    <c:v>0</c:v>
                  </c:pt>
                  <c:pt idx="7">
                    <c:v>0.8507884394317528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0:$I$10</c:f>
              <c:numCache>
                <c:formatCode>General</c:formatCode>
                <c:ptCount val="8"/>
                <c:pt idx="0">
                  <c:v>0</c:v>
                </c:pt>
                <c:pt idx="1">
                  <c:v>35.730230065164612</c:v>
                </c:pt>
                <c:pt idx="2">
                  <c:v>0.11878951453200566</c:v>
                </c:pt>
                <c:pt idx="3">
                  <c:v>0</c:v>
                </c:pt>
                <c:pt idx="4">
                  <c:v>1.648159524542997</c:v>
                </c:pt>
                <c:pt idx="5">
                  <c:v>0</c:v>
                </c:pt>
                <c:pt idx="6">
                  <c:v>0</c:v>
                </c:pt>
                <c:pt idx="7">
                  <c:v>5.40515326477816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95E-3A45-B52D-F1F9E9074FC7}"/>
            </c:ext>
          </c:extLst>
        </c:ser>
        <c:ser>
          <c:idx val="2"/>
          <c:order val="2"/>
          <c:tx>
            <c:strRef>
              <c:f>summary!$A$11</c:f>
              <c:strCache>
                <c:ptCount val="1"/>
                <c:pt idx="0">
                  <c:v>Leo1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1:$R$11</c:f>
                <c:numCache>
                  <c:formatCode>General</c:formatCode>
                  <c:ptCount val="8"/>
                  <c:pt idx="0">
                    <c:v>0.15226179590815916</c:v>
                  </c:pt>
                  <c:pt idx="1">
                    <c:v>1.3589525484830902</c:v>
                  </c:pt>
                  <c:pt idx="2">
                    <c:v>0.21310592568181694</c:v>
                  </c:pt>
                  <c:pt idx="3">
                    <c:v>0</c:v>
                  </c:pt>
                  <c:pt idx="4">
                    <c:v>2.2564475420997137</c:v>
                  </c:pt>
                  <c:pt idx="5">
                    <c:v>0</c:v>
                  </c:pt>
                  <c:pt idx="6">
                    <c:v>3.1235406142104356E-2</c:v>
                  </c:pt>
                  <c:pt idx="7">
                    <c:v>0.43072334894688963</c:v>
                  </c:pt>
                </c:numCache>
              </c:numRef>
            </c:plus>
            <c:minus>
              <c:numRef>
                <c:f>summary!$K$11:$R$11</c:f>
                <c:numCache>
                  <c:formatCode>General</c:formatCode>
                  <c:ptCount val="8"/>
                  <c:pt idx="0">
                    <c:v>0.15226179590815916</c:v>
                  </c:pt>
                  <c:pt idx="1">
                    <c:v>1.3589525484830902</c:v>
                  </c:pt>
                  <c:pt idx="2">
                    <c:v>0.21310592568181694</c:v>
                  </c:pt>
                  <c:pt idx="3">
                    <c:v>0</c:v>
                  </c:pt>
                  <c:pt idx="4">
                    <c:v>2.2564475420997137</c:v>
                  </c:pt>
                  <c:pt idx="5">
                    <c:v>0</c:v>
                  </c:pt>
                  <c:pt idx="6">
                    <c:v>3.1235406142104356E-2</c:v>
                  </c:pt>
                  <c:pt idx="7">
                    <c:v>0.430723348946889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1:$I$11</c:f>
              <c:numCache>
                <c:formatCode>General</c:formatCode>
                <c:ptCount val="8"/>
                <c:pt idx="0">
                  <c:v>0.10766534840230146</c:v>
                </c:pt>
                <c:pt idx="1">
                  <c:v>24.046936463311209</c:v>
                </c:pt>
                <c:pt idx="2">
                  <c:v>0.1506886451606492</c:v>
                </c:pt>
                <c:pt idx="3">
                  <c:v>0</c:v>
                </c:pt>
                <c:pt idx="4">
                  <c:v>1.6712066883578871</c:v>
                </c:pt>
                <c:pt idx="5">
                  <c:v>0</c:v>
                </c:pt>
                <c:pt idx="6">
                  <c:v>2.2086767496197927E-2</c:v>
                </c:pt>
                <c:pt idx="7">
                  <c:v>4.75882115902967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95E-3A45-B52D-F1F9E9074FC7}"/>
            </c:ext>
          </c:extLst>
        </c:ser>
        <c:ser>
          <c:idx val="3"/>
          <c:order val="3"/>
          <c:tx>
            <c:strRef>
              <c:f>summary!$A$12</c:f>
              <c:strCache>
                <c:ptCount val="1"/>
                <c:pt idx="0">
                  <c:v>Cdc73t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2:$R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0741056544676919</c:v>
                  </c:pt>
                  <c:pt idx="2">
                    <c:v>0.21582885523239617</c:v>
                  </c:pt>
                  <c:pt idx="3">
                    <c:v>0.17010475558315497</c:v>
                  </c:pt>
                  <c:pt idx="4">
                    <c:v>2.9914647736675843</c:v>
                  </c:pt>
                  <c:pt idx="5">
                    <c:v>5.8525600333183214E-2</c:v>
                  </c:pt>
                  <c:pt idx="6">
                    <c:v>9.2216284232141135E-2</c:v>
                  </c:pt>
                  <c:pt idx="7">
                    <c:v>0.72669055519974524</c:v>
                  </c:pt>
                </c:numCache>
              </c:numRef>
            </c:plus>
            <c:minus>
              <c:numRef>
                <c:f>summary!$K$12:$R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0741056544676919</c:v>
                  </c:pt>
                  <c:pt idx="2">
                    <c:v>0.21582885523239617</c:v>
                  </c:pt>
                  <c:pt idx="3">
                    <c:v>0.17010475558315497</c:v>
                  </c:pt>
                  <c:pt idx="4">
                    <c:v>2.9914647736675843</c:v>
                  </c:pt>
                  <c:pt idx="5">
                    <c:v>5.8525600333183214E-2</c:v>
                  </c:pt>
                  <c:pt idx="6">
                    <c:v>9.2216284232141135E-2</c:v>
                  </c:pt>
                  <c:pt idx="7">
                    <c:v>0.726690555199745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2:$I$12</c:f>
              <c:numCache>
                <c:formatCode>General</c:formatCode>
                <c:ptCount val="8"/>
                <c:pt idx="0">
                  <c:v>0</c:v>
                </c:pt>
                <c:pt idx="1">
                  <c:v>32.156840844911756</c:v>
                </c:pt>
                <c:pt idx="2">
                  <c:v>0.2206335009862003</c:v>
                </c:pt>
                <c:pt idx="3">
                  <c:v>0.12028222618492911</c:v>
                </c:pt>
                <c:pt idx="4">
                  <c:v>2.1152850271410295</c:v>
                </c:pt>
                <c:pt idx="5">
                  <c:v>4.138384886860752E-2</c:v>
                </c:pt>
                <c:pt idx="6">
                  <c:v>6.5206759916373105E-2</c:v>
                </c:pt>
                <c:pt idx="7">
                  <c:v>6.35517554643074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95E-3A45-B52D-F1F9E9074FC7}"/>
            </c:ext>
          </c:extLst>
        </c:ser>
        <c:ser>
          <c:idx val="4"/>
          <c:order val="4"/>
          <c:tx>
            <c:strRef>
              <c:f>summary!$A$13</c:f>
              <c:strCache>
                <c:ptCount val="1"/>
                <c:pt idx="0">
                  <c:v>Tplus3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3:$R$1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72563288379610413</c:v>
                  </c:pt>
                  <c:pt idx="2">
                    <c:v>4.5865761457929546E-2</c:v>
                  </c:pt>
                  <c:pt idx="3">
                    <c:v>0</c:v>
                  </c:pt>
                  <c:pt idx="4">
                    <c:v>0.87183395114997642</c:v>
                  </c:pt>
                  <c:pt idx="5">
                    <c:v>0</c:v>
                  </c:pt>
                  <c:pt idx="6">
                    <c:v>0</c:v>
                  </c:pt>
                  <c:pt idx="7">
                    <c:v>0.4049302350054676</c:v>
                  </c:pt>
                </c:numCache>
              </c:numRef>
            </c:plus>
            <c:minus>
              <c:numRef>
                <c:f>summary!$K$13:$R$1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72563288379610413</c:v>
                  </c:pt>
                  <c:pt idx="2">
                    <c:v>4.5865761457929546E-2</c:v>
                  </c:pt>
                  <c:pt idx="3">
                    <c:v>0</c:v>
                  </c:pt>
                  <c:pt idx="4">
                    <c:v>0.87183395114997642</c:v>
                  </c:pt>
                  <c:pt idx="5">
                    <c:v>0</c:v>
                  </c:pt>
                  <c:pt idx="6">
                    <c:v>0</c:v>
                  </c:pt>
                  <c:pt idx="7">
                    <c:v>0.40493023500546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3:$I$13</c:f>
              <c:numCache>
                <c:formatCode>General</c:formatCode>
                <c:ptCount val="8"/>
                <c:pt idx="0">
                  <c:v>0</c:v>
                </c:pt>
                <c:pt idx="1">
                  <c:v>4.2552715298858077</c:v>
                </c:pt>
                <c:pt idx="2">
                  <c:v>3.2431990951186575E-2</c:v>
                </c:pt>
                <c:pt idx="3">
                  <c:v>0</c:v>
                </c:pt>
                <c:pt idx="4">
                  <c:v>0.61647969892680943</c:v>
                </c:pt>
                <c:pt idx="5">
                  <c:v>0</c:v>
                </c:pt>
                <c:pt idx="6">
                  <c:v>0</c:v>
                </c:pt>
                <c:pt idx="7">
                  <c:v>2.12340182311801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95E-3A45-B52D-F1F9E9074FC7}"/>
            </c:ext>
          </c:extLst>
        </c:ser>
        <c:ser>
          <c:idx val="5"/>
          <c:order val="5"/>
          <c:tx>
            <c:strRef>
              <c:f>summary!$A$14</c:f>
              <c:strCache>
                <c:ptCount val="1"/>
                <c:pt idx="0">
                  <c:v>Rtf1t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4:$R$14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2.804195801600667</c:v>
                  </c:pt>
                  <c:pt idx="2">
                    <c:v>0.49068179827650521</c:v>
                  </c:pt>
                  <c:pt idx="3">
                    <c:v>0.14093365070897951</c:v>
                  </c:pt>
                  <c:pt idx="4">
                    <c:v>18.501706903904768</c:v>
                  </c:pt>
                  <c:pt idx="5">
                    <c:v>6.6018615999475214E-2</c:v>
                  </c:pt>
                  <c:pt idx="6">
                    <c:v>0.11460330030543441</c:v>
                  </c:pt>
                  <c:pt idx="7">
                    <c:v>6.6362680590396437</c:v>
                  </c:pt>
                </c:numCache>
              </c:numRef>
            </c:plus>
            <c:minus>
              <c:numRef>
                <c:f>summary!$K$14:$R$14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2.804195801600667</c:v>
                  </c:pt>
                  <c:pt idx="2">
                    <c:v>0.49068179827650521</c:v>
                  </c:pt>
                  <c:pt idx="3">
                    <c:v>0.14093365070897951</c:v>
                  </c:pt>
                  <c:pt idx="4">
                    <c:v>18.501706903904768</c:v>
                  </c:pt>
                  <c:pt idx="5">
                    <c:v>6.6018615999475214E-2</c:v>
                  </c:pt>
                  <c:pt idx="6">
                    <c:v>0.11460330030543441</c:v>
                  </c:pt>
                  <c:pt idx="7">
                    <c:v>6.63626805903964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4:$I$14</c:f>
              <c:numCache>
                <c:formatCode>General</c:formatCode>
                <c:ptCount val="8"/>
                <c:pt idx="0">
                  <c:v>0</c:v>
                </c:pt>
                <c:pt idx="1">
                  <c:v>187.19512349581046</c:v>
                </c:pt>
                <c:pt idx="2">
                  <c:v>1.0262401645922512</c:v>
                </c:pt>
                <c:pt idx="3">
                  <c:v>9.9655140113695681E-2</c:v>
                </c:pt>
                <c:pt idx="4">
                  <c:v>13.266712953647291</c:v>
                </c:pt>
                <c:pt idx="5">
                  <c:v>9.1124594314710913E-2</c:v>
                </c:pt>
                <c:pt idx="6">
                  <c:v>8.1036770792331E-2</c:v>
                </c:pt>
                <c:pt idx="7">
                  <c:v>41.6950213085479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295E-3A45-B52D-F1F9E9074F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9990768"/>
        <c:axId val="399992768"/>
      </c:barChart>
      <c:catAx>
        <c:axId val="399990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2768"/>
        <c:crosses val="autoZero"/>
        <c:auto val="1"/>
        <c:lblAlgn val="ctr"/>
        <c:lblOffset val="100"/>
        <c:noMultiLvlLbl val="0"/>
      </c:catAx>
      <c:valAx>
        <c:axId val="39999276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076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8017935258092741"/>
          <c:y val="6.7586206896551718E-2"/>
          <c:w val="0.16417796733741619"/>
          <c:h val="0.351414660124006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en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A$8</c:f>
              <c:strCache>
                <c:ptCount val="1"/>
                <c:pt idx="0">
                  <c:v>Ctr9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8:$R$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8726507200111477</c:v>
                  </c:pt>
                  <c:pt idx="2">
                    <c:v>2.1794714436014918E-2</c:v>
                  </c:pt>
                  <c:pt idx="3">
                    <c:v>5.558910764103938E-2</c:v>
                  </c:pt>
                  <c:pt idx="4">
                    <c:v>3.7600530541791577E-2</c:v>
                  </c:pt>
                  <c:pt idx="5">
                    <c:v>0.10644416246688809</c:v>
                  </c:pt>
                  <c:pt idx="6">
                    <c:v>6.2767773146286579E-2</c:v>
                  </c:pt>
                  <c:pt idx="7">
                    <c:v>0.40598007632649502</c:v>
                  </c:pt>
                </c:numCache>
              </c:numRef>
            </c:plus>
            <c:minus>
              <c:numRef>
                <c:f>summary!$K$8:$R$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8726507200111477</c:v>
                  </c:pt>
                  <c:pt idx="2">
                    <c:v>2.1794714436014918E-2</c:v>
                  </c:pt>
                  <c:pt idx="3">
                    <c:v>5.558910764103938E-2</c:v>
                  </c:pt>
                  <c:pt idx="4">
                    <c:v>3.7600530541791577E-2</c:v>
                  </c:pt>
                  <c:pt idx="5">
                    <c:v>0.10644416246688809</c:v>
                  </c:pt>
                  <c:pt idx="6">
                    <c:v>6.2767773146286579E-2</c:v>
                  </c:pt>
                  <c:pt idx="7">
                    <c:v>0.405980076326495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8:$I$8</c:f>
              <c:numCache>
                <c:formatCode>General</c:formatCode>
                <c:ptCount val="8"/>
                <c:pt idx="0">
                  <c:v>0</c:v>
                </c:pt>
                <c:pt idx="1">
                  <c:v>33.339044655000727</c:v>
                </c:pt>
                <c:pt idx="2">
                  <c:v>1.5411190371730487E-2</c:v>
                </c:pt>
                <c:pt idx="3">
                  <c:v>0.22342289176514105</c:v>
                </c:pt>
                <c:pt idx="4">
                  <c:v>0.1218263918651496</c:v>
                </c:pt>
                <c:pt idx="5">
                  <c:v>0.14434977484053937</c:v>
                </c:pt>
                <c:pt idx="6">
                  <c:v>4.4383518031718111E-2</c:v>
                </c:pt>
                <c:pt idx="7">
                  <c:v>5.0112540676923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C6-914B-9FD5-DE7810A1DCD7}"/>
            </c:ext>
          </c:extLst>
        </c:ser>
        <c:ser>
          <c:idx val="1"/>
          <c:order val="1"/>
          <c:tx>
            <c:strRef>
              <c:f>summary!$A$9</c:f>
              <c:strCache>
                <c:ptCount val="1"/>
                <c:pt idx="0">
                  <c:v>Paf1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9:$R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4.578068189310521</c:v>
                  </c:pt>
                  <c:pt idx="2">
                    <c:v>0.17277395424091091</c:v>
                  </c:pt>
                  <c:pt idx="3">
                    <c:v>0.15588099076508619</c:v>
                  </c:pt>
                  <c:pt idx="4">
                    <c:v>0.2067489661565742</c:v>
                  </c:pt>
                  <c:pt idx="5">
                    <c:v>0.18366235150315674</c:v>
                  </c:pt>
                  <c:pt idx="6">
                    <c:v>0</c:v>
                  </c:pt>
                  <c:pt idx="7">
                    <c:v>1.1585508049247706</c:v>
                  </c:pt>
                </c:numCache>
              </c:numRef>
            </c:plus>
            <c:minus>
              <c:numRef>
                <c:f>summary!$K$9:$R$9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4.578068189310521</c:v>
                  </c:pt>
                  <c:pt idx="2">
                    <c:v>0.17277395424091091</c:v>
                  </c:pt>
                  <c:pt idx="3">
                    <c:v>0.15588099076508619</c:v>
                  </c:pt>
                  <c:pt idx="4">
                    <c:v>0.2067489661565742</c:v>
                  </c:pt>
                  <c:pt idx="5">
                    <c:v>0.18366235150315674</c:v>
                  </c:pt>
                  <c:pt idx="6">
                    <c:v>0</c:v>
                  </c:pt>
                  <c:pt idx="7">
                    <c:v>1.15855080492477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9:$I$9</c:f>
              <c:numCache>
                <c:formatCode>General</c:formatCode>
                <c:ptCount val="8"/>
                <c:pt idx="0">
                  <c:v>0</c:v>
                </c:pt>
                <c:pt idx="1">
                  <c:v>69.869827008881344</c:v>
                </c:pt>
                <c:pt idx="2">
                  <c:v>0.12216963465616239</c:v>
                </c:pt>
                <c:pt idx="3">
                  <c:v>0.11022450562807005</c:v>
                </c:pt>
                <c:pt idx="4">
                  <c:v>0.32995731201465123</c:v>
                </c:pt>
                <c:pt idx="5">
                  <c:v>0.12986889419654943</c:v>
                </c:pt>
                <c:pt idx="6">
                  <c:v>0</c:v>
                </c:pt>
                <c:pt idx="7">
                  <c:v>7.95209985495734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5C6-914B-9FD5-DE7810A1DCD7}"/>
            </c:ext>
          </c:extLst>
        </c:ser>
        <c:ser>
          <c:idx val="2"/>
          <c:order val="2"/>
          <c:tx>
            <c:strRef>
              <c:f>summary!$A$10</c:f>
              <c:strCache>
                <c:ptCount val="1"/>
                <c:pt idx="0">
                  <c:v>Leo1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0:$R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6.3094537400091495</c:v>
                  </c:pt>
                  <c:pt idx="2">
                    <c:v>5.5638680650377109E-2</c:v>
                  </c:pt>
                  <c:pt idx="3">
                    <c:v>7.5297917756888474E-2</c:v>
                  </c:pt>
                  <c:pt idx="4">
                    <c:v>0.12613338045193606</c:v>
                  </c:pt>
                  <c:pt idx="5">
                    <c:v>0.13307645054067976</c:v>
                  </c:pt>
                  <c:pt idx="6">
                    <c:v>0</c:v>
                  </c:pt>
                  <c:pt idx="7">
                    <c:v>7.5562075894133066E-2</c:v>
                  </c:pt>
                </c:numCache>
              </c:numRef>
            </c:plus>
            <c:minus>
              <c:numRef>
                <c:f>summary!$K$10:$R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6.3094537400091495</c:v>
                  </c:pt>
                  <c:pt idx="2">
                    <c:v>5.5638680650377109E-2</c:v>
                  </c:pt>
                  <c:pt idx="3">
                    <c:v>7.5297917756888474E-2</c:v>
                  </c:pt>
                  <c:pt idx="4">
                    <c:v>0.12613338045193606</c:v>
                  </c:pt>
                  <c:pt idx="5">
                    <c:v>0.13307645054067976</c:v>
                  </c:pt>
                  <c:pt idx="6">
                    <c:v>0</c:v>
                  </c:pt>
                  <c:pt idx="7">
                    <c:v>7.55620758941330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0:$I$10</c:f>
              <c:numCache>
                <c:formatCode>General</c:formatCode>
                <c:ptCount val="8"/>
                <c:pt idx="0">
                  <c:v>0</c:v>
                </c:pt>
                <c:pt idx="1">
                  <c:v>40.487869067533687</c:v>
                </c:pt>
                <c:pt idx="2">
                  <c:v>3.9342488384154405E-2</c:v>
                </c:pt>
                <c:pt idx="3">
                  <c:v>5.3243668255122785E-2</c:v>
                </c:pt>
                <c:pt idx="4">
                  <c:v>0.12972699029270018</c:v>
                </c:pt>
                <c:pt idx="5">
                  <c:v>9.4099260593550851E-2</c:v>
                </c:pt>
                <c:pt idx="6">
                  <c:v>0</c:v>
                </c:pt>
                <c:pt idx="7">
                  <c:v>4.93298113066526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5C6-914B-9FD5-DE7810A1DCD7}"/>
            </c:ext>
          </c:extLst>
        </c:ser>
        <c:ser>
          <c:idx val="3"/>
          <c:order val="3"/>
          <c:tx>
            <c:strRef>
              <c:f>summary!$A$11</c:f>
              <c:strCache>
                <c:ptCount val="1"/>
                <c:pt idx="0">
                  <c:v>Cdc73t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1:$R$11</c:f>
                <c:numCache>
                  <c:formatCode>General</c:formatCode>
                  <c:ptCount val="8"/>
                  <c:pt idx="0">
                    <c:v>6.566206196887879E-2</c:v>
                  </c:pt>
                  <c:pt idx="1">
                    <c:v>5.000276509435885</c:v>
                  </c:pt>
                  <c:pt idx="2">
                    <c:v>0.28009271564356503</c:v>
                  </c:pt>
                  <c:pt idx="3">
                    <c:v>0.12635333321052172</c:v>
                  </c:pt>
                  <c:pt idx="4">
                    <c:v>7.0381963567981293E-2</c:v>
                  </c:pt>
                  <c:pt idx="5">
                    <c:v>6.9274479298415625E-2</c:v>
                  </c:pt>
                  <c:pt idx="6">
                    <c:v>0</c:v>
                  </c:pt>
                  <c:pt idx="7">
                    <c:v>0.80063328823410629</c:v>
                  </c:pt>
                </c:numCache>
              </c:numRef>
            </c:plus>
            <c:minus>
              <c:numRef>
                <c:f>summary!$K$11:$R$11</c:f>
                <c:numCache>
                  <c:formatCode>General</c:formatCode>
                  <c:ptCount val="8"/>
                  <c:pt idx="0">
                    <c:v>6.566206196887879E-2</c:v>
                  </c:pt>
                  <c:pt idx="1">
                    <c:v>5.000276509435885</c:v>
                  </c:pt>
                  <c:pt idx="2">
                    <c:v>0.28009271564356503</c:v>
                  </c:pt>
                  <c:pt idx="3">
                    <c:v>0.12635333321052172</c:v>
                  </c:pt>
                  <c:pt idx="4">
                    <c:v>7.0381963567981293E-2</c:v>
                  </c:pt>
                  <c:pt idx="5">
                    <c:v>6.9274479298415625E-2</c:v>
                  </c:pt>
                  <c:pt idx="6">
                    <c:v>0</c:v>
                  </c:pt>
                  <c:pt idx="7">
                    <c:v>0.800633288234106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1:$I$11</c:f>
              <c:numCache>
                <c:formatCode>General</c:formatCode>
                <c:ptCount val="8"/>
                <c:pt idx="0">
                  <c:v>4.6430089284885505E-2</c:v>
                </c:pt>
                <c:pt idx="1">
                  <c:v>43.952405924637482</c:v>
                </c:pt>
                <c:pt idx="2">
                  <c:v>0.19805545859252024</c:v>
                </c:pt>
                <c:pt idx="3">
                  <c:v>8.9345298738683299E-2</c:v>
                </c:pt>
                <c:pt idx="4">
                  <c:v>4.9767563712144108E-2</c:v>
                </c:pt>
                <c:pt idx="5">
                  <c:v>4.8984454075076796E-2</c:v>
                </c:pt>
                <c:pt idx="6">
                  <c:v>0</c:v>
                </c:pt>
                <c:pt idx="7">
                  <c:v>6.13598070206068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5C6-914B-9FD5-DE7810A1DCD7}"/>
            </c:ext>
          </c:extLst>
        </c:ser>
        <c:ser>
          <c:idx val="4"/>
          <c:order val="4"/>
          <c:tx>
            <c:strRef>
              <c:f>summary!$A$12</c:f>
              <c:strCache>
                <c:ptCount val="1"/>
                <c:pt idx="0">
                  <c:v>tPlus3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2:$R$12</c:f>
                <c:numCache>
                  <c:formatCode>General</c:formatCode>
                  <c:ptCount val="8"/>
                  <c:pt idx="0">
                    <c:v>0.13954464347473144</c:v>
                  </c:pt>
                  <c:pt idx="1">
                    <c:v>4.9982183572725658</c:v>
                  </c:pt>
                  <c:pt idx="2">
                    <c:v>3.4767241373503344E-2</c:v>
                  </c:pt>
                  <c:pt idx="3">
                    <c:v>4.6189982231447387E-2</c:v>
                  </c:pt>
                  <c:pt idx="4">
                    <c:v>0.31450843540547568</c:v>
                  </c:pt>
                  <c:pt idx="5">
                    <c:v>0.14541689290008794</c:v>
                  </c:pt>
                  <c:pt idx="6">
                    <c:v>0</c:v>
                  </c:pt>
                  <c:pt idx="7">
                    <c:v>0.24418131091336112</c:v>
                  </c:pt>
                </c:numCache>
              </c:numRef>
            </c:plus>
            <c:minus>
              <c:numRef>
                <c:f>summary!$K$12:$R$12</c:f>
                <c:numCache>
                  <c:formatCode>General</c:formatCode>
                  <c:ptCount val="8"/>
                  <c:pt idx="0">
                    <c:v>0.13954464347473144</c:v>
                  </c:pt>
                  <c:pt idx="1">
                    <c:v>4.9982183572725658</c:v>
                  </c:pt>
                  <c:pt idx="2">
                    <c:v>3.4767241373503344E-2</c:v>
                  </c:pt>
                  <c:pt idx="3">
                    <c:v>4.6189982231447387E-2</c:v>
                  </c:pt>
                  <c:pt idx="4">
                    <c:v>0.31450843540547568</c:v>
                  </c:pt>
                  <c:pt idx="5">
                    <c:v>0.14541689290008794</c:v>
                  </c:pt>
                  <c:pt idx="6">
                    <c:v>0</c:v>
                  </c:pt>
                  <c:pt idx="7">
                    <c:v>0.2441813109133611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2:$I$12</c:f>
              <c:numCache>
                <c:formatCode>General</c:formatCode>
                <c:ptCount val="8"/>
                <c:pt idx="0">
                  <c:v>0.5116869866895476</c:v>
                </c:pt>
                <c:pt idx="1">
                  <c:v>18.226570672962485</c:v>
                </c:pt>
                <c:pt idx="2">
                  <c:v>2.4584152138353712E-2</c:v>
                </c:pt>
                <c:pt idx="3">
                  <c:v>6.528632249100759E-2</c:v>
                </c:pt>
                <c:pt idx="4">
                  <c:v>0.22239104741558313</c:v>
                </c:pt>
                <c:pt idx="5">
                  <c:v>0.19056450403009051</c:v>
                </c:pt>
                <c:pt idx="6">
                  <c:v>0</c:v>
                </c:pt>
                <c:pt idx="7">
                  <c:v>2.6367862181776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5C6-914B-9FD5-DE7810A1DCD7}"/>
            </c:ext>
          </c:extLst>
        </c:ser>
        <c:ser>
          <c:idx val="5"/>
          <c:order val="5"/>
          <c:tx>
            <c:strRef>
              <c:f>summary!$A$13</c:f>
              <c:strCache>
                <c:ptCount val="1"/>
                <c:pt idx="0">
                  <c:v>Rtf1t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3:$R$1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2529529796643981</c:v>
                  </c:pt>
                  <c:pt idx="2">
                    <c:v>0.19133023803417046</c:v>
                  </c:pt>
                  <c:pt idx="3">
                    <c:v>1.2289835925554651</c:v>
                  </c:pt>
                  <c:pt idx="4">
                    <c:v>0.2402889385530769</c:v>
                  </c:pt>
                  <c:pt idx="5">
                    <c:v>2.8576811505144288</c:v>
                  </c:pt>
                  <c:pt idx="6">
                    <c:v>0.22922294376169</c:v>
                  </c:pt>
                  <c:pt idx="7">
                    <c:v>1.820462162162477</c:v>
                  </c:pt>
                </c:numCache>
              </c:numRef>
            </c:plus>
            <c:minus>
              <c:numRef>
                <c:f>summary!$K$13:$R$13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2529529796643981</c:v>
                  </c:pt>
                  <c:pt idx="2">
                    <c:v>0.19133023803417046</c:v>
                  </c:pt>
                  <c:pt idx="3">
                    <c:v>1.2289835925554651</c:v>
                  </c:pt>
                  <c:pt idx="4">
                    <c:v>0.2402889385530769</c:v>
                  </c:pt>
                  <c:pt idx="5">
                    <c:v>2.8576811505144288</c:v>
                  </c:pt>
                  <c:pt idx="6">
                    <c:v>0.22922294376169</c:v>
                  </c:pt>
                  <c:pt idx="7">
                    <c:v>1.8204621621624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3:$I$13</c:f>
              <c:numCache>
                <c:formatCode>General</c:formatCode>
                <c:ptCount val="8"/>
                <c:pt idx="0">
                  <c:v>0</c:v>
                </c:pt>
                <c:pt idx="1">
                  <c:v>130.82981457189609</c:v>
                </c:pt>
                <c:pt idx="2">
                  <c:v>0.26966967204119746</c:v>
                </c:pt>
                <c:pt idx="3">
                  <c:v>0.86902263226297427</c:v>
                </c:pt>
                <c:pt idx="4">
                  <c:v>0.25726627534804591</c:v>
                </c:pt>
                <c:pt idx="5">
                  <c:v>2.3083983850864001</c:v>
                </c:pt>
                <c:pt idx="6">
                  <c:v>0.16208509793743361</c:v>
                </c:pt>
                <c:pt idx="7">
                  <c:v>19.4208760891976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F5C6-914B-9FD5-DE7810A1DC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9990768"/>
        <c:axId val="399992768"/>
      </c:barChart>
      <c:catAx>
        <c:axId val="399990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2768"/>
        <c:crosses val="autoZero"/>
        <c:auto val="1"/>
        <c:lblAlgn val="ctr"/>
        <c:lblOffset val="100"/>
        <c:noMultiLvlLbl val="0"/>
      </c:catAx>
      <c:valAx>
        <c:axId val="39999276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076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8017935258092741"/>
          <c:y val="6.7586206896551718E-2"/>
          <c:w val="0.16417796733741619"/>
          <c:h val="0.351414660124006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en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A$3</c:f>
              <c:strCache>
                <c:ptCount val="1"/>
                <c:pt idx="0">
                  <c:v>Ctr9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3:$R$3</c:f>
                <c:numCache>
                  <c:formatCode>General</c:formatCode>
                  <c:ptCount val="8"/>
                  <c:pt idx="0">
                    <c:v>3.660014619593039</c:v>
                  </c:pt>
                  <c:pt idx="1">
                    <c:v>4.5315104819589447</c:v>
                  </c:pt>
                  <c:pt idx="2">
                    <c:v>0.56956713712439011</c:v>
                  </c:pt>
                  <c:pt idx="3">
                    <c:v>1.5347005879310247</c:v>
                  </c:pt>
                  <c:pt idx="4">
                    <c:v>1.5428422109924511</c:v>
                  </c:pt>
                  <c:pt idx="5">
                    <c:v>0.40197102568226789</c:v>
                  </c:pt>
                  <c:pt idx="6">
                    <c:v>5.0968874716376273</c:v>
                  </c:pt>
                  <c:pt idx="7">
                    <c:v>0.35896905901457982</c:v>
                  </c:pt>
                </c:numCache>
              </c:numRef>
            </c:plus>
            <c:minus>
              <c:numRef>
                <c:f>summary!$K$3:$R$3</c:f>
                <c:numCache>
                  <c:formatCode>General</c:formatCode>
                  <c:ptCount val="8"/>
                  <c:pt idx="0">
                    <c:v>3.660014619593039</c:v>
                  </c:pt>
                  <c:pt idx="1">
                    <c:v>4.5315104819589447</c:v>
                  </c:pt>
                  <c:pt idx="2">
                    <c:v>0.56956713712439011</c:v>
                  </c:pt>
                  <c:pt idx="3">
                    <c:v>1.5347005879310247</c:v>
                  </c:pt>
                  <c:pt idx="4">
                    <c:v>1.5428422109924511</c:v>
                  </c:pt>
                  <c:pt idx="5">
                    <c:v>0.40197102568226789</c:v>
                  </c:pt>
                  <c:pt idx="6">
                    <c:v>5.0968874716376273</c:v>
                  </c:pt>
                  <c:pt idx="7">
                    <c:v>0.358969059014579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3:$I$3</c:f>
              <c:numCache>
                <c:formatCode>General</c:formatCode>
                <c:ptCount val="8"/>
                <c:pt idx="0">
                  <c:v>54.631762800364875</c:v>
                </c:pt>
                <c:pt idx="1">
                  <c:v>42.346300420489719</c:v>
                </c:pt>
                <c:pt idx="2">
                  <c:v>7.1885140880563547</c:v>
                </c:pt>
                <c:pt idx="3">
                  <c:v>8.0640488252458393</c:v>
                </c:pt>
                <c:pt idx="4">
                  <c:v>18.18780143683081</c:v>
                </c:pt>
                <c:pt idx="5">
                  <c:v>16.537828397150125</c:v>
                </c:pt>
                <c:pt idx="6">
                  <c:v>17.207947628259237</c:v>
                </c:pt>
                <c:pt idx="7">
                  <c:v>18.24443302284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EF3-3D4C-B6B8-B4F912F57F8D}"/>
            </c:ext>
          </c:extLst>
        </c:ser>
        <c:ser>
          <c:idx val="1"/>
          <c:order val="1"/>
          <c:tx>
            <c:strRef>
              <c:f>summary!$A$4</c:f>
              <c:strCache>
                <c:ptCount val="1"/>
                <c:pt idx="0">
                  <c:v>Paf1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4:$R$4</c:f>
                <c:numCache>
                  <c:formatCode>General</c:formatCode>
                  <c:ptCount val="8"/>
                  <c:pt idx="0">
                    <c:v>10.180604454367684</c:v>
                  </c:pt>
                  <c:pt idx="1">
                    <c:v>1.5554457028059745</c:v>
                  </c:pt>
                  <c:pt idx="2">
                    <c:v>2.7370396266637425</c:v>
                  </c:pt>
                  <c:pt idx="3">
                    <c:v>1.838484474049729</c:v>
                  </c:pt>
                  <c:pt idx="4">
                    <c:v>3.8859119450890152</c:v>
                  </c:pt>
                  <c:pt idx="5">
                    <c:v>0.39159594985803281</c:v>
                  </c:pt>
                  <c:pt idx="6">
                    <c:v>13.930428868036152</c:v>
                  </c:pt>
                  <c:pt idx="7">
                    <c:v>0.99340483595576357</c:v>
                  </c:pt>
                </c:numCache>
              </c:numRef>
            </c:plus>
            <c:minus>
              <c:numRef>
                <c:f>summary!$K$4:$R$4</c:f>
                <c:numCache>
                  <c:formatCode>General</c:formatCode>
                  <c:ptCount val="8"/>
                  <c:pt idx="0">
                    <c:v>10.180604454367684</c:v>
                  </c:pt>
                  <c:pt idx="1">
                    <c:v>1.5554457028059745</c:v>
                  </c:pt>
                  <c:pt idx="2">
                    <c:v>2.7370396266637425</c:v>
                  </c:pt>
                  <c:pt idx="3">
                    <c:v>1.838484474049729</c:v>
                  </c:pt>
                  <c:pt idx="4">
                    <c:v>3.8859119450890152</c:v>
                  </c:pt>
                  <c:pt idx="5">
                    <c:v>0.39159594985803281</c:v>
                  </c:pt>
                  <c:pt idx="6">
                    <c:v>13.930428868036152</c:v>
                  </c:pt>
                  <c:pt idx="7">
                    <c:v>0.993404835955763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4:$I$4</c:f>
              <c:numCache>
                <c:formatCode>General</c:formatCode>
                <c:ptCount val="8"/>
                <c:pt idx="0">
                  <c:v>95.677130171644123</c:v>
                </c:pt>
                <c:pt idx="1">
                  <c:v>29.000242740934421</c:v>
                </c:pt>
                <c:pt idx="2">
                  <c:v>21.608061994533255</c:v>
                </c:pt>
                <c:pt idx="3">
                  <c:v>12.835304756165621</c:v>
                </c:pt>
                <c:pt idx="4">
                  <c:v>35.101846385650354</c:v>
                </c:pt>
                <c:pt idx="5">
                  <c:v>17.365496148470992</c:v>
                </c:pt>
                <c:pt idx="6">
                  <c:v>60.35050539767375</c:v>
                </c:pt>
                <c:pt idx="7">
                  <c:v>23.8972721456995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EF3-3D4C-B6B8-B4F912F57F8D}"/>
            </c:ext>
          </c:extLst>
        </c:ser>
        <c:ser>
          <c:idx val="2"/>
          <c:order val="2"/>
          <c:tx>
            <c:strRef>
              <c:f>summary!$A$5</c:f>
              <c:strCache>
                <c:ptCount val="1"/>
                <c:pt idx="0">
                  <c:v>Leo1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5:$R$5</c:f>
                <c:numCache>
                  <c:formatCode>General</c:formatCode>
                  <c:ptCount val="8"/>
                  <c:pt idx="0">
                    <c:v>6.1184105676385343</c:v>
                  </c:pt>
                  <c:pt idx="1">
                    <c:v>1.8066954928000674</c:v>
                  </c:pt>
                  <c:pt idx="2">
                    <c:v>1.846377851987377</c:v>
                  </c:pt>
                  <c:pt idx="3">
                    <c:v>1.9595950488825629</c:v>
                  </c:pt>
                  <c:pt idx="4">
                    <c:v>2.3076206173460947</c:v>
                  </c:pt>
                  <c:pt idx="5">
                    <c:v>0.46263626984050332</c:v>
                  </c:pt>
                  <c:pt idx="6">
                    <c:v>3.204093932694819</c:v>
                  </c:pt>
                  <c:pt idx="7">
                    <c:v>0.31205604458170738</c:v>
                  </c:pt>
                </c:numCache>
              </c:numRef>
            </c:plus>
            <c:minus>
              <c:numRef>
                <c:f>summary!$K$5:$R$5</c:f>
                <c:numCache>
                  <c:formatCode>General</c:formatCode>
                  <c:ptCount val="8"/>
                  <c:pt idx="0">
                    <c:v>6.1184105676385343</c:v>
                  </c:pt>
                  <c:pt idx="1">
                    <c:v>1.8066954928000674</c:v>
                  </c:pt>
                  <c:pt idx="2">
                    <c:v>1.846377851987377</c:v>
                  </c:pt>
                  <c:pt idx="3">
                    <c:v>1.9595950488825629</c:v>
                  </c:pt>
                  <c:pt idx="4">
                    <c:v>2.3076206173460947</c:v>
                  </c:pt>
                  <c:pt idx="5">
                    <c:v>0.46263626984050332</c:v>
                  </c:pt>
                  <c:pt idx="6">
                    <c:v>3.204093932694819</c:v>
                  </c:pt>
                  <c:pt idx="7">
                    <c:v>0.312056044581707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5:$I$5</c:f>
              <c:numCache>
                <c:formatCode>General</c:formatCode>
                <c:ptCount val="8"/>
                <c:pt idx="0">
                  <c:v>55.676232346027398</c:v>
                </c:pt>
                <c:pt idx="1">
                  <c:v>29.564163383563358</c:v>
                </c:pt>
                <c:pt idx="2">
                  <c:v>9.6529975057863115</c:v>
                </c:pt>
                <c:pt idx="3">
                  <c:v>11.016988997445877</c:v>
                </c:pt>
                <c:pt idx="4">
                  <c:v>24.968849328229663</c:v>
                </c:pt>
                <c:pt idx="5">
                  <c:v>15.786683081453509</c:v>
                </c:pt>
                <c:pt idx="6">
                  <c:v>21.133391968340941</c:v>
                </c:pt>
                <c:pt idx="7">
                  <c:v>17.7211554015896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2EF3-3D4C-B6B8-B4F912F57F8D}"/>
            </c:ext>
          </c:extLst>
        </c:ser>
        <c:ser>
          <c:idx val="3"/>
          <c:order val="3"/>
          <c:tx>
            <c:strRef>
              <c:f>summary!$A$6</c:f>
              <c:strCache>
                <c:ptCount val="1"/>
                <c:pt idx="0">
                  <c:v>Cdc73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6:$R$6</c:f>
                <c:numCache>
                  <c:formatCode>General</c:formatCode>
                  <c:ptCount val="8"/>
                  <c:pt idx="0">
                    <c:v>9.2579528936598532</c:v>
                  </c:pt>
                  <c:pt idx="1">
                    <c:v>2.2990537974867387</c:v>
                  </c:pt>
                  <c:pt idx="2">
                    <c:v>0.93748340199613944</c:v>
                  </c:pt>
                  <c:pt idx="3">
                    <c:v>0.61575403213286484</c:v>
                  </c:pt>
                  <c:pt idx="4">
                    <c:v>2.3631591246071437</c:v>
                  </c:pt>
                  <c:pt idx="5">
                    <c:v>2.1080108088592313</c:v>
                  </c:pt>
                  <c:pt idx="6">
                    <c:v>8.9786442287070862</c:v>
                  </c:pt>
                  <c:pt idx="7">
                    <c:v>2.5648452294074464</c:v>
                  </c:pt>
                </c:numCache>
              </c:numRef>
            </c:plus>
            <c:minus>
              <c:numRef>
                <c:f>summary!$K$6:$R$6</c:f>
                <c:numCache>
                  <c:formatCode>General</c:formatCode>
                  <c:ptCount val="8"/>
                  <c:pt idx="0">
                    <c:v>9.2579528936598532</c:v>
                  </c:pt>
                  <c:pt idx="1">
                    <c:v>2.2990537974867387</c:v>
                  </c:pt>
                  <c:pt idx="2">
                    <c:v>0.93748340199613944</c:v>
                  </c:pt>
                  <c:pt idx="3">
                    <c:v>0.61575403213286484</c:v>
                  </c:pt>
                  <c:pt idx="4">
                    <c:v>2.3631591246071437</c:v>
                  </c:pt>
                  <c:pt idx="5">
                    <c:v>2.1080108088592313</c:v>
                  </c:pt>
                  <c:pt idx="6">
                    <c:v>8.9786442287070862</c:v>
                  </c:pt>
                  <c:pt idx="7">
                    <c:v>2.56484522940744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6:$I$6</c:f>
              <c:numCache>
                <c:formatCode>General</c:formatCode>
                <c:ptCount val="8"/>
                <c:pt idx="0">
                  <c:v>77.132029552750893</c:v>
                </c:pt>
                <c:pt idx="1">
                  <c:v>21.395239717719917</c:v>
                </c:pt>
                <c:pt idx="2">
                  <c:v>10.635635448493609</c:v>
                </c:pt>
                <c:pt idx="3">
                  <c:v>8.8071163061756383</c:v>
                </c:pt>
                <c:pt idx="4">
                  <c:v>21.497513187326096</c:v>
                </c:pt>
                <c:pt idx="5">
                  <c:v>15.325925616454546</c:v>
                </c:pt>
                <c:pt idx="6">
                  <c:v>19.744339631970071</c:v>
                </c:pt>
                <c:pt idx="7">
                  <c:v>13.578052768991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2EF3-3D4C-B6B8-B4F912F57F8D}"/>
            </c:ext>
          </c:extLst>
        </c:ser>
        <c:ser>
          <c:idx val="4"/>
          <c:order val="4"/>
          <c:tx>
            <c:strRef>
              <c:f>summary!$A$7</c:f>
              <c:strCache>
                <c:ptCount val="1"/>
                <c:pt idx="0">
                  <c:v>Rtf1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7:$R$7</c:f>
                <c:numCache>
                  <c:formatCode>General</c:formatCode>
                  <c:ptCount val="8"/>
                  <c:pt idx="0">
                    <c:v>15.086581939502329</c:v>
                  </c:pt>
                  <c:pt idx="1">
                    <c:v>4.1972281740190587</c:v>
                  </c:pt>
                  <c:pt idx="2">
                    <c:v>2.5926128874238303</c:v>
                  </c:pt>
                  <c:pt idx="3">
                    <c:v>2.1722135679025749</c:v>
                  </c:pt>
                  <c:pt idx="4">
                    <c:v>6.3258367688466635</c:v>
                  </c:pt>
                  <c:pt idx="5">
                    <c:v>3.9197135627079773</c:v>
                  </c:pt>
                  <c:pt idx="6">
                    <c:v>11.282168536897489</c:v>
                  </c:pt>
                  <c:pt idx="7">
                    <c:v>4.7356062703553468</c:v>
                  </c:pt>
                </c:numCache>
              </c:numRef>
            </c:plus>
            <c:minus>
              <c:numRef>
                <c:f>summary!$K$7:$R$7</c:f>
                <c:numCache>
                  <c:formatCode>General</c:formatCode>
                  <c:ptCount val="8"/>
                  <c:pt idx="0">
                    <c:v>15.086581939502329</c:v>
                  </c:pt>
                  <c:pt idx="1">
                    <c:v>4.1972281740190587</c:v>
                  </c:pt>
                  <c:pt idx="2">
                    <c:v>2.5926128874238303</c:v>
                  </c:pt>
                  <c:pt idx="3">
                    <c:v>2.1722135679025749</c:v>
                  </c:pt>
                  <c:pt idx="4">
                    <c:v>6.3258367688466635</c:v>
                  </c:pt>
                  <c:pt idx="5">
                    <c:v>3.9197135627079773</c:v>
                  </c:pt>
                  <c:pt idx="6">
                    <c:v>11.282168536897489</c:v>
                  </c:pt>
                  <c:pt idx="7">
                    <c:v>4.73560627035534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7:$I$7</c:f>
              <c:numCache>
                <c:formatCode>General</c:formatCode>
                <c:ptCount val="8"/>
                <c:pt idx="0">
                  <c:v>119.25428530992714</c:v>
                </c:pt>
                <c:pt idx="1">
                  <c:v>50.025649685799614</c:v>
                </c:pt>
                <c:pt idx="2">
                  <c:v>12.989240374896278</c:v>
                </c:pt>
                <c:pt idx="3">
                  <c:v>19.443783006832287</c:v>
                </c:pt>
                <c:pt idx="4">
                  <c:v>44.321245105862232</c:v>
                </c:pt>
                <c:pt idx="5">
                  <c:v>22.104524935227118</c:v>
                </c:pt>
                <c:pt idx="6">
                  <c:v>49.720736799784468</c:v>
                </c:pt>
                <c:pt idx="7">
                  <c:v>36.3731327938447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EF3-3D4C-B6B8-B4F912F57F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9990768"/>
        <c:axId val="399992768"/>
      </c:barChart>
      <c:catAx>
        <c:axId val="399990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2768"/>
        <c:crosses val="autoZero"/>
        <c:auto val="1"/>
        <c:lblAlgn val="ctr"/>
        <c:lblOffset val="100"/>
        <c:noMultiLvlLbl val="0"/>
      </c:catAx>
      <c:valAx>
        <c:axId val="39999276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076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8017935258092741"/>
          <c:y val="6.7586206896551718E-2"/>
          <c:w val="0.16417796733741619"/>
          <c:h val="0.3127673171288371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en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mmary!$A$8</c:f>
              <c:strCache>
                <c:ptCount val="1"/>
                <c:pt idx="0">
                  <c:v>Ctr9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8:$R$8</c:f>
                <c:numCache>
                  <c:formatCode>General</c:formatCode>
                  <c:ptCount val="8"/>
                  <c:pt idx="0">
                    <c:v>9.9414839678189176E-2</c:v>
                  </c:pt>
                  <c:pt idx="1">
                    <c:v>2.9348791339798188</c:v>
                  </c:pt>
                  <c:pt idx="2">
                    <c:v>0</c:v>
                  </c:pt>
                  <c:pt idx="3">
                    <c:v>0</c:v>
                  </c:pt>
                  <c:pt idx="4">
                    <c:v>3.5871157873284522E-2</c:v>
                  </c:pt>
                  <c:pt idx="5">
                    <c:v>7.0468703076889169E-2</c:v>
                  </c:pt>
                  <c:pt idx="6">
                    <c:v>2.3521699626064332E-2</c:v>
                  </c:pt>
                  <c:pt idx="7">
                    <c:v>0.76721557506643601</c:v>
                  </c:pt>
                </c:numCache>
              </c:numRef>
            </c:plus>
            <c:minus>
              <c:numRef>
                <c:f>summary!$K$8:$R$8</c:f>
                <c:numCache>
                  <c:formatCode>General</c:formatCode>
                  <c:ptCount val="8"/>
                  <c:pt idx="0">
                    <c:v>9.9414839678189176E-2</c:v>
                  </c:pt>
                  <c:pt idx="1">
                    <c:v>2.9348791339798188</c:v>
                  </c:pt>
                  <c:pt idx="2">
                    <c:v>0</c:v>
                  </c:pt>
                  <c:pt idx="3">
                    <c:v>0</c:v>
                  </c:pt>
                  <c:pt idx="4">
                    <c:v>3.5871157873284522E-2</c:v>
                  </c:pt>
                  <c:pt idx="5">
                    <c:v>7.0468703076889169E-2</c:v>
                  </c:pt>
                  <c:pt idx="6">
                    <c:v>2.3521699626064332E-2</c:v>
                  </c:pt>
                  <c:pt idx="7">
                    <c:v>0.767215575066436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8:$I$8</c:f>
              <c:numCache>
                <c:formatCode>General</c:formatCode>
                <c:ptCount val="8"/>
                <c:pt idx="0">
                  <c:v>0.16223480261266707</c:v>
                </c:pt>
                <c:pt idx="1">
                  <c:v>20.479053420637566</c:v>
                </c:pt>
                <c:pt idx="2">
                  <c:v>0</c:v>
                </c:pt>
                <c:pt idx="3">
                  <c:v>0</c:v>
                </c:pt>
                <c:pt idx="4">
                  <c:v>2.5364738981212696E-2</c:v>
                </c:pt>
                <c:pt idx="5">
                  <c:v>7.4011079986556511E-2</c:v>
                </c:pt>
                <c:pt idx="6">
                  <c:v>1.6632353310623169E-2</c:v>
                </c:pt>
                <c:pt idx="7">
                  <c:v>5.71633974846525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835-D342-8DE8-0FD861BE4886}"/>
            </c:ext>
          </c:extLst>
        </c:ser>
        <c:ser>
          <c:idx val="1"/>
          <c:order val="1"/>
          <c:tx>
            <c:strRef>
              <c:f>summary!$A$9</c:f>
              <c:strCache>
                <c:ptCount val="1"/>
                <c:pt idx="0">
                  <c:v>Paf1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9:$R$9</c:f>
                <c:numCache>
                  <c:formatCode>General</c:formatCode>
                  <c:ptCount val="8"/>
                  <c:pt idx="0">
                    <c:v>0.12342301905167986</c:v>
                  </c:pt>
                  <c:pt idx="1">
                    <c:v>2.0442274046391948</c:v>
                  </c:pt>
                  <c:pt idx="2">
                    <c:v>0.44231949888065003</c:v>
                  </c:pt>
                  <c:pt idx="3">
                    <c:v>0</c:v>
                  </c:pt>
                  <c:pt idx="4">
                    <c:v>0.31034702225481958</c:v>
                  </c:pt>
                  <c:pt idx="5">
                    <c:v>0.43284307289987461</c:v>
                  </c:pt>
                  <c:pt idx="6">
                    <c:v>1.3895544104433921</c:v>
                  </c:pt>
                  <c:pt idx="7">
                    <c:v>1.4724451080136973</c:v>
                  </c:pt>
                </c:numCache>
              </c:numRef>
            </c:plus>
            <c:minus>
              <c:numRef>
                <c:f>summary!$K$9:$R$9</c:f>
                <c:numCache>
                  <c:formatCode>General</c:formatCode>
                  <c:ptCount val="8"/>
                  <c:pt idx="0">
                    <c:v>0.12342301905167986</c:v>
                  </c:pt>
                  <c:pt idx="1">
                    <c:v>2.0442274046391948</c:v>
                  </c:pt>
                  <c:pt idx="2">
                    <c:v>0.44231949888065003</c:v>
                  </c:pt>
                  <c:pt idx="3">
                    <c:v>0</c:v>
                  </c:pt>
                  <c:pt idx="4">
                    <c:v>0.31034702225481958</c:v>
                  </c:pt>
                  <c:pt idx="5">
                    <c:v>0.43284307289987461</c:v>
                  </c:pt>
                  <c:pt idx="6">
                    <c:v>1.3895544104433921</c:v>
                  </c:pt>
                  <c:pt idx="7">
                    <c:v>1.47244510801369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9:$I$9</c:f>
              <c:numCache>
                <c:formatCode>General</c:formatCode>
                <c:ptCount val="8"/>
                <c:pt idx="0">
                  <c:v>8.7273253725959288E-2</c:v>
                </c:pt>
                <c:pt idx="1">
                  <c:v>19.594349183182981</c:v>
                </c:pt>
                <c:pt idx="2">
                  <c:v>0.60775723331136677</c:v>
                </c:pt>
                <c:pt idx="3">
                  <c:v>0</c:v>
                </c:pt>
                <c:pt idx="4">
                  <c:v>0.43653786547475137</c:v>
                </c:pt>
                <c:pt idx="5">
                  <c:v>0.70721262769043414</c:v>
                </c:pt>
                <c:pt idx="6">
                  <c:v>1.3829181511443804</c:v>
                </c:pt>
                <c:pt idx="7">
                  <c:v>5.65794802630552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835-D342-8DE8-0FD861BE4886}"/>
            </c:ext>
          </c:extLst>
        </c:ser>
        <c:ser>
          <c:idx val="2"/>
          <c:order val="2"/>
          <c:tx>
            <c:strRef>
              <c:f>summary!$A$10</c:f>
              <c:strCache>
                <c:ptCount val="1"/>
                <c:pt idx="0">
                  <c:v>Leo1t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0:$R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4722768336060383</c:v>
                  </c:pt>
                  <c:pt idx="2">
                    <c:v>0.17787864605037124</c:v>
                  </c:pt>
                  <c:pt idx="3">
                    <c:v>0</c:v>
                  </c:pt>
                  <c:pt idx="4">
                    <c:v>0</c:v>
                  </c:pt>
                  <c:pt idx="5">
                    <c:v>0.21297269437538704</c:v>
                  </c:pt>
                  <c:pt idx="6">
                    <c:v>0.12589852390086664</c:v>
                  </c:pt>
                  <c:pt idx="7">
                    <c:v>1.0044572432299399</c:v>
                  </c:pt>
                </c:numCache>
              </c:numRef>
            </c:plus>
            <c:minus>
              <c:numRef>
                <c:f>summary!$K$10:$R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5.4722768336060383</c:v>
                  </c:pt>
                  <c:pt idx="2">
                    <c:v>0.17787864605037124</c:v>
                  </c:pt>
                  <c:pt idx="3">
                    <c:v>0</c:v>
                  </c:pt>
                  <c:pt idx="4">
                    <c:v>0</c:v>
                  </c:pt>
                  <c:pt idx="5">
                    <c:v>0.21297269437538704</c:v>
                  </c:pt>
                  <c:pt idx="6">
                    <c:v>0.12589852390086664</c:v>
                  </c:pt>
                  <c:pt idx="7">
                    <c:v>1.00445724322993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0:$I$10</c:f>
              <c:numCache>
                <c:formatCode>General</c:formatCode>
                <c:ptCount val="8"/>
                <c:pt idx="0">
                  <c:v>0</c:v>
                </c:pt>
                <c:pt idx="1">
                  <c:v>35.679418458855011</c:v>
                </c:pt>
                <c:pt idx="2">
                  <c:v>0.12577919685049918</c:v>
                </c:pt>
                <c:pt idx="3">
                  <c:v>0</c:v>
                </c:pt>
                <c:pt idx="4">
                  <c:v>0</c:v>
                </c:pt>
                <c:pt idx="5">
                  <c:v>0.15059443640040626</c:v>
                </c:pt>
                <c:pt idx="6">
                  <c:v>8.9023699991679417E-2</c:v>
                </c:pt>
                <c:pt idx="7">
                  <c:v>9.1057188196888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835-D342-8DE8-0FD861BE4886}"/>
            </c:ext>
          </c:extLst>
        </c:ser>
        <c:ser>
          <c:idx val="4"/>
          <c:order val="3"/>
          <c:tx>
            <c:strRef>
              <c:f>summary!$A$11</c:f>
              <c:strCache>
                <c:ptCount val="1"/>
                <c:pt idx="0">
                  <c:v>tPlus3</c:v>
                </c:pt>
              </c:strCache>
            </c:strRef>
          </c:tx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1:$R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5986216852081871</c:v>
                  </c:pt>
                  <c:pt idx="2">
                    <c:v>0</c:v>
                  </c:pt>
                  <c:pt idx="3">
                    <c:v>6.1334304757111713E-2</c:v>
                  </c:pt>
                  <c:pt idx="4">
                    <c:v>0</c:v>
                  </c:pt>
                  <c:pt idx="5">
                    <c:v>0.49317320172298768</c:v>
                  </c:pt>
                  <c:pt idx="6">
                    <c:v>0.35710688273192953</c:v>
                  </c:pt>
                  <c:pt idx="7">
                    <c:v>0.51610517521629629</c:v>
                  </c:pt>
                </c:numCache>
              </c:numRef>
            </c:plus>
            <c:minus>
              <c:numRef>
                <c:f>summary!$K$11:$R$1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5986216852081871</c:v>
                  </c:pt>
                  <c:pt idx="2">
                    <c:v>0</c:v>
                  </c:pt>
                  <c:pt idx="3">
                    <c:v>6.1334304757111713E-2</c:v>
                  </c:pt>
                  <c:pt idx="4">
                    <c:v>0</c:v>
                  </c:pt>
                  <c:pt idx="5">
                    <c:v>0.49317320172298768</c:v>
                  </c:pt>
                  <c:pt idx="6">
                    <c:v>0.35710688273192953</c:v>
                  </c:pt>
                  <c:pt idx="7">
                    <c:v>0.516105175216296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1:$I$11</c:f>
              <c:numCache>
                <c:formatCode>General</c:formatCode>
                <c:ptCount val="8"/>
                <c:pt idx="0">
                  <c:v>0</c:v>
                </c:pt>
                <c:pt idx="1">
                  <c:v>44.353041926764149</c:v>
                </c:pt>
                <c:pt idx="2">
                  <c:v>0</c:v>
                </c:pt>
                <c:pt idx="3">
                  <c:v>8.6246292097086341E-2</c:v>
                </c:pt>
                <c:pt idx="4">
                  <c:v>0</c:v>
                </c:pt>
                <c:pt idx="5">
                  <c:v>0.46211200034221678</c:v>
                </c:pt>
                <c:pt idx="6">
                  <c:v>0.25251269838813661</c:v>
                </c:pt>
                <c:pt idx="7">
                  <c:v>17.4152945446406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835-D342-8DE8-0FD861BE4886}"/>
            </c:ext>
          </c:extLst>
        </c:ser>
        <c:ser>
          <c:idx val="5"/>
          <c:order val="4"/>
          <c:tx>
            <c:strRef>
              <c:f>summary!$A$12</c:f>
              <c:strCache>
                <c:ptCount val="1"/>
                <c:pt idx="0">
                  <c:v>Rtf1t</c:v>
                </c:pt>
              </c:strCache>
            </c:strRef>
          </c:tx>
          <c:spPr>
            <a:solidFill>
              <a:schemeClr val="accent5">
                <a:lumMod val="60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mmary!$K$12:$R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7945526157810607</c:v>
                  </c:pt>
                  <c:pt idx="2">
                    <c:v>0.24044451343098092</c:v>
                  </c:pt>
                  <c:pt idx="3">
                    <c:v>0.11775473585860655</c:v>
                  </c:pt>
                  <c:pt idx="4">
                    <c:v>0</c:v>
                  </c:pt>
                  <c:pt idx="5">
                    <c:v>0.51618052584008423</c:v>
                  </c:pt>
                  <c:pt idx="6">
                    <c:v>0.83557997877098744</c:v>
                  </c:pt>
                  <c:pt idx="7">
                    <c:v>0.48905495025270013</c:v>
                  </c:pt>
                </c:numCache>
              </c:numRef>
            </c:plus>
            <c:minus>
              <c:numRef>
                <c:f>summary!$K$12:$R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3.7945526157810607</c:v>
                  </c:pt>
                  <c:pt idx="2">
                    <c:v>0.24044451343098092</c:v>
                  </c:pt>
                  <c:pt idx="3">
                    <c:v>0.11775473585860655</c:v>
                  </c:pt>
                  <c:pt idx="4">
                    <c:v>0</c:v>
                  </c:pt>
                  <c:pt idx="5">
                    <c:v>0.51618052584008423</c:v>
                  </c:pt>
                  <c:pt idx="6">
                    <c:v>0.83557997877098744</c:v>
                  </c:pt>
                  <c:pt idx="7">
                    <c:v>0.489054950252700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mmary!$B$2:$I$2</c:f>
              <c:strCache>
                <c:ptCount val="8"/>
                <c:pt idx="0">
                  <c:v>GO_f</c:v>
                </c:pt>
                <c:pt idx="1">
                  <c:v>GO_m</c:v>
                </c:pt>
                <c:pt idx="2">
                  <c:v>RE_m</c:v>
                </c:pt>
                <c:pt idx="3">
                  <c:v>DG_m</c:v>
                </c:pt>
                <c:pt idx="4">
                  <c:v>HD_m</c:v>
                </c:pt>
                <c:pt idx="5">
                  <c:v>AC_m</c:v>
                </c:pt>
                <c:pt idx="6">
                  <c:v>TX_m</c:v>
                </c:pt>
                <c:pt idx="7">
                  <c:v>WB_m</c:v>
                </c:pt>
              </c:strCache>
            </c:strRef>
          </c:cat>
          <c:val>
            <c:numRef>
              <c:f>summary!$B$12:$I$12</c:f>
              <c:numCache>
                <c:formatCode>General</c:formatCode>
                <c:ptCount val="8"/>
                <c:pt idx="0">
                  <c:v>0</c:v>
                </c:pt>
                <c:pt idx="1">
                  <c:v>66.898975581674435</c:v>
                </c:pt>
                <c:pt idx="2">
                  <c:v>0.30527869211385411</c:v>
                </c:pt>
                <c:pt idx="3">
                  <c:v>8.3265172242451405E-2</c:v>
                </c:pt>
                <c:pt idx="4">
                  <c:v>0</c:v>
                </c:pt>
                <c:pt idx="5">
                  <c:v>0.45751510435187548</c:v>
                </c:pt>
                <c:pt idx="6">
                  <c:v>0.70317644590798378</c:v>
                </c:pt>
                <c:pt idx="7">
                  <c:v>21.6432833285730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0835-D342-8DE8-0FD861BE48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99990768"/>
        <c:axId val="399992768"/>
      </c:barChart>
      <c:catAx>
        <c:axId val="3999907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2768"/>
        <c:crosses val="autoZero"/>
        <c:auto val="1"/>
        <c:lblAlgn val="ctr"/>
        <c:lblOffset val="100"/>
        <c:noMultiLvlLbl val="0"/>
      </c:catAx>
      <c:valAx>
        <c:axId val="399992768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elvetica" pitchFamily="2" charset="0"/>
                <a:ea typeface="+mn-ea"/>
                <a:cs typeface="+mn-cs"/>
              </a:defRPr>
            </a:pPr>
            <a:endParaRPr lang="en-JP"/>
          </a:p>
        </c:txPr>
        <c:crossAx val="39999076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8017935258092741"/>
          <c:y val="6.7586206896551718E-2"/>
          <c:w val="0.16417796733741619"/>
          <c:h val="0.351414660124006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0" i="1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Helvetica" pitchFamily="2" charset="0"/>
              <a:ea typeface="+mn-ea"/>
              <a:cs typeface="+mn-cs"/>
            </a:defRPr>
          </a:pPr>
          <a:endParaRPr lang="en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>
          <a:latin typeface="Helvetica" pitchFamily="2" charset="0"/>
        </a:defRPr>
      </a:pPr>
      <a:endParaRPr lang="en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1">
  <a:schemeClr val="accent1"/>
  <a:schemeClr val="accent3"/>
  <a:schemeClr val="accent5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AF3D8A-BF40-814B-B08F-01DDF89C8908}" type="datetimeFigureOut">
              <a:t>2025/07/20</a:t>
            </a:fld>
            <a:endParaRPr lang="en-JP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JP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90BDBD-BAAE-7B4C-9AE9-308A1AA48290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0318222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90BDBD-BAAE-7B4C-9AE9-308A1AA48290}" type="slidenum">
              <a:t>1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687534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77475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966586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63747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57761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076848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010360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8714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57968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02556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5917974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998350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7DEAD-1BC0-C04C-8CAE-219FE4C30F7D}" type="datetimeFigureOut">
              <a:t>2025/07/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32606F-1F9A-DB4F-A3EC-AC6A42BCDDB8}" type="slidenum"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800228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5.xml"/><Relationship Id="rId3" Type="http://schemas.openxmlformats.org/officeDocument/2006/relationships/chart" Target="../charts/chart1.xml"/><Relationship Id="rId7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image" Target="../media/image1.png"/><Relationship Id="rId9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" name="Chart 23">
            <a:extLst>
              <a:ext uri="{FF2B5EF4-FFF2-40B4-BE49-F238E27FC236}">
                <a16:creationId xmlns:a16="http://schemas.microsoft.com/office/drawing/2014/main" id="{0C9246E1-846B-8747-8E57-361C683180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966361"/>
              </p:ext>
            </p:extLst>
          </p:nvPr>
        </p:nvGraphicFramePr>
        <p:xfrm>
          <a:off x="318956" y="5104290"/>
          <a:ext cx="3528635" cy="1858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4" name="TextBox 53">
            <a:extLst>
              <a:ext uri="{FF2B5EF4-FFF2-40B4-BE49-F238E27FC236}">
                <a16:creationId xmlns:a16="http://schemas.microsoft.com/office/drawing/2014/main" id="{BA6A3D0E-CF87-3769-7EFB-BB9CC9789A48}"/>
              </a:ext>
            </a:extLst>
          </p:cNvPr>
          <p:cNvSpPr txBox="1"/>
          <p:nvPr/>
        </p:nvSpPr>
        <p:spPr>
          <a:xfrm>
            <a:off x="2907" y="10330278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600">
                <a:latin typeface="Helvetica" pitchFamily="2" charset="0"/>
              </a:rPr>
              <a:t>Figure S1</a:t>
            </a:r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50DA2BFD-A7C6-82AC-392F-1BCAD2E9DF1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4958" b="23227"/>
          <a:stretch/>
        </p:blipFill>
        <p:spPr>
          <a:xfrm>
            <a:off x="462585" y="247918"/>
            <a:ext cx="4236453" cy="4645656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797AD916-0EB7-FEE5-1C2D-5C1BE1D0EB9D}"/>
              </a:ext>
            </a:extLst>
          </p:cNvPr>
          <p:cNvSpPr txBox="1"/>
          <p:nvPr/>
        </p:nvSpPr>
        <p:spPr>
          <a:xfrm>
            <a:off x="1075637" y="4216245"/>
            <a:ext cx="3261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0.1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7E1EE42F-1BC8-5356-4AFE-04BFD7A61CC7}"/>
              </a:ext>
            </a:extLst>
          </p:cNvPr>
          <p:cNvCxnSpPr>
            <a:cxnSpLocks/>
          </p:cNvCxnSpPr>
          <p:nvPr/>
        </p:nvCxnSpPr>
        <p:spPr>
          <a:xfrm>
            <a:off x="4213411" y="388361"/>
            <a:ext cx="0" cy="1211561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E9B5C18D-1496-2C6A-A3C9-657D63004EB7}"/>
              </a:ext>
            </a:extLst>
          </p:cNvPr>
          <p:cNvCxnSpPr>
            <a:cxnSpLocks/>
          </p:cNvCxnSpPr>
          <p:nvPr/>
        </p:nvCxnSpPr>
        <p:spPr>
          <a:xfrm>
            <a:off x="4217214" y="1634205"/>
            <a:ext cx="0" cy="1116766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06DAAB8F-5509-F589-3FFF-7B381C96B3AB}"/>
              </a:ext>
            </a:extLst>
          </p:cNvPr>
          <p:cNvCxnSpPr>
            <a:cxnSpLocks/>
          </p:cNvCxnSpPr>
          <p:nvPr/>
        </p:nvCxnSpPr>
        <p:spPr>
          <a:xfrm>
            <a:off x="3485855" y="3269635"/>
            <a:ext cx="0" cy="1211561"/>
          </a:xfrm>
          <a:prstGeom prst="line">
            <a:avLst/>
          </a:prstGeom>
          <a:ln w="127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C7F0D868-0D06-7269-62CE-FB539C1CFB2F}"/>
              </a:ext>
            </a:extLst>
          </p:cNvPr>
          <p:cNvCxnSpPr>
            <a:cxnSpLocks/>
          </p:cNvCxnSpPr>
          <p:nvPr/>
        </p:nvCxnSpPr>
        <p:spPr>
          <a:xfrm>
            <a:off x="1163113" y="4411615"/>
            <a:ext cx="151200" cy="0"/>
          </a:xfrm>
          <a:prstGeom prst="line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80D72B1A-2230-1489-84B3-DEF092FECF6C}"/>
              </a:ext>
            </a:extLst>
          </p:cNvPr>
          <p:cNvSpPr txBox="1"/>
          <p:nvPr/>
        </p:nvSpPr>
        <p:spPr>
          <a:xfrm>
            <a:off x="3479558" y="3843263"/>
            <a:ext cx="889716" cy="3729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 i="1">
                <a:latin typeface="Helvetica" pitchFamily="2" charset="0"/>
              </a:rPr>
              <a:t>Drosophilidae</a:t>
            </a:r>
          </a:p>
          <a:p>
            <a:pPr algn="l"/>
            <a:r>
              <a:rPr lang="en-JP" sz="600">
                <a:latin typeface="Helvetica" pitchFamily="2" charset="0"/>
              </a:rPr>
              <a:t>general </a:t>
            </a:r>
            <a:r>
              <a:rPr lang="en-JP" sz="600" i="1">
                <a:latin typeface="Helvetica" pitchFamily="2" charset="0"/>
              </a:rPr>
              <a:t>Rtf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68059EA-1507-CB06-56C4-06EE4B0921B9}"/>
              </a:ext>
            </a:extLst>
          </p:cNvPr>
          <p:cNvSpPr txBox="1"/>
          <p:nvPr/>
        </p:nvSpPr>
        <p:spPr>
          <a:xfrm>
            <a:off x="4217214" y="871963"/>
            <a:ext cx="7432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 i="1">
                <a:latin typeface="Helvetica" pitchFamily="2" charset="0"/>
              </a:rPr>
              <a:t>Drosophilidae </a:t>
            </a:r>
          </a:p>
          <a:p>
            <a:pPr algn="l"/>
            <a:r>
              <a:rPr lang="en-JP" sz="600" i="1">
                <a:latin typeface="Helvetica" pitchFamily="2" charset="0"/>
              </a:rPr>
              <a:t>Rtf1 </a:t>
            </a:r>
            <a:r>
              <a:rPr lang="en-JP" sz="600">
                <a:latin typeface="Helvetica" pitchFamily="2" charset="0"/>
              </a:rPr>
              <a:t>paralogue</a:t>
            </a:r>
          </a:p>
          <a:p>
            <a:pPr algn="l"/>
            <a:r>
              <a:rPr lang="en-JP" sz="600">
                <a:latin typeface="Helvetica" pitchFamily="2" charset="0"/>
              </a:rPr>
              <a:t>group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98C8064-6A52-96F2-6936-2B7F75F91F0C}"/>
              </a:ext>
            </a:extLst>
          </p:cNvPr>
          <p:cNvSpPr txBox="1"/>
          <p:nvPr/>
        </p:nvSpPr>
        <p:spPr>
          <a:xfrm>
            <a:off x="4198594" y="2045590"/>
            <a:ext cx="743257" cy="3729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JP" sz="600" i="1">
                <a:latin typeface="Helvetica" pitchFamily="2" charset="0"/>
              </a:rPr>
              <a:t>Drosophilidae </a:t>
            </a:r>
          </a:p>
          <a:p>
            <a:pPr algn="l"/>
            <a:r>
              <a:rPr lang="en-JP" sz="600" i="1">
                <a:latin typeface="Helvetica" pitchFamily="2" charset="0"/>
              </a:rPr>
              <a:t>Rtf1 </a:t>
            </a:r>
            <a:r>
              <a:rPr lang="en-JP" sz="600">
                <a:latin typeface="Helvetica" pitchFamily="2" charset="0"/>
              </a:rPr>
              <a:t>paralogue</a:t>
            </a:r>
          </a:p>
          <a:p>
            <a:pPr algn="l"/>
            <a:r>
              <a:rPr lang="en-JP" sz="600">
                <a:latin typeface="Helvetica" pitchFamily="2" charset="0"/>
              </a:rPr>
              <a:t>group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9E741342-DD69-0AE8-F982-23F9C6A22466}"/>
              </a:ext>
            </a:extLst>
          </p:cNvPr>
          <p:cNvSpPr/>
          <p:nvPr/>
        </p:nvSpPr>
        <p:spPr>
          <a:xfrm>
            <a:off x="2205194" y="3269635"/>
            <a:ext cx="1280661" cy="1211561"/>
          </a:xfrm>
          <a:prstGeom prst="rect">
            <a:avLst/>
          </a:prstGeom>
          <a:solidFill>
            <a:schemeClr val="accent5">
              <a:lumMod val="60000"/>
              <a:lumOff val="40000"/>
              <a:alpha val="1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C1A220B-C037-09B0-8D0A-97E88C8C40EC}"/>
              </a:ext>
            </a:extLst>
          </p:cNvPr>
          <p:cNvSpPr/>
          <p:nvPr/>
        </p:nvSpPr>
        <p:spPr>
          <a:xfrm>
            <a:off x="1930406" y="1599922"/>
            <a:ext cx="2283005" cy="1211561"/>
          </a:xfrm>
          <a:prstGeom prst="rect">
            <a:avLst/>
          </a:prstGeom>
          <a:solidFill>
            <a:schemeClr val="accent4">
              <a:lumMod val="60000"/>
              <a:lumOff val="40000"/>
              <a:alpha val="1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79CF1A8E-2FD3-FB66-0111-AED0F8FC8E6C}"/>
              </a:ext>
            </a:extLst>
          </p:cNvPr>
          <p:cNvSpPr/>
          <p:nvPr/>
        </p:nvSpPr>
        <p:spPr>
          <a:xfrm>
            <a:off x="1798931" y="388361"/>
            <a:ext cx="2414480" cy="1211561"/>
          </a:xfrm>
          <a:prstGeom prst="rect">
            <a:avLst/>
          </a:prstGeom>
          <a:solidFill>
            <a:schemeClr val="accent4">
              <a:lumMod val="75000"/>
              <a:alpha val="1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JP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E452215-533B-B0C3-ADDE-62330891771A}"/>
              </a:ext>
            </a:extLst>
          </p:cNvPr>
          <p:cNvSpPr txBox="1"/>
          <p:nvPr/>
        </p:nvSpPr>
        <p:spPr>
          <a:xfrm>
            <a:off x="57251" y="491956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B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3E04BF1-3BE4-35F2-FEFE-2FA35603403D}"/>
              </a:ext>
            </a:extLst>
          </p:cNvPr>
          <p:cNvSpPr txBox="1"/>
          <p:nvPr/>
        </p:nvSpPr>
        <p:spPr>
          <a:xfrm>
            <a:off x="59311" y="7864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600">
                <a:latin typeface="Helvetica" pitchFamily="2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9DFD42A-0267-EDFC-BB54-0C832D655510}"/>
              </a:ext>
            </a:extLst>
          </p:cNvPr>
          <p:cNvSpPr txBox="1"/>
          <p:nvPr/>
        </p:nvSpPr>
        <p:spPr>
          <a:xfrm rot="16200000">
            <a:off x="-60505" y="7417236"/>
            <a:ext cx="6880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Mean TPM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13A0BF0-3F31-169D-8333-B83145EB8E28}"/>
              </a:ext>
            </a:extLst>
          </p:cNvPr>
          <p:cNvSpPr txBox="1"/>
          <p:nvPr/>
        </p:nvSpPr>
        <p:spPr>
          <a:xfrm>
            <a:off x="1448443" y="6971396"/>
            <a:ext cx="10406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 i="1">
                <a:latin typeface="Helvetica" pitchFamily="2" charset="0"/>
              </a:rPr>
              <a:t>D. ananassea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9F14D2F-CEE6-F923-CD1A-91AA453A9CE8}"/>
              </a:ext>
            </a:extLst>
          </p:cNvPr>
          <p:cNvSpPr txBox="1"/>
          <p:nvPr/>
        </p:nvSpPr>
        <p:spPr>
          <a:xfrm>
            <a:off x="4972812" y="6953929"/>
            <a:ext cx="10406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 i="1">
                <a:latin typeface="Helvetica" pitchFamily="2" charset="0"/>
              </a:rPr>
              <a:t>D. ananassea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7BC1366-39F4-DF2D-3CB8-C86367C503DF}"/>
              </a:ext>
            </a:extLst>
          </p:cNvPr>
          <p:cNvSpPr txBox="1"/>
          <p:nvPr/>
        </p:nvSpPr>
        <p:spPr>
          <a:xfrm rot="16200000">
            <a:off x="-60504" y="5799380"/>
            <a:ext cx="6880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Mean TP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4F715FD-A45C-94B3-FF01-616B90BA2265}"/>
              </a:ext>
            </a:extLst>
          </p:cNvPr>
          <p:cNvSpPr txBox="1"/>
          <p:nvPr/>
        </p:nvSpPr>
        <p:spPr>
          <a:xfrm>
            <a:off x="1589508" y="5203476"/>
            <a:ext cx="7585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 i="1">
                <a:latin typeface="Helvetica" pitchFamily="2" charset="0"/>
              </a:rPr>
              <a:t>D. yakub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33B2EE3-EE37-BFD2-C488-360B2D687B2E}"/>
              </a:ext>
            </a:extLst>
          </p:cNvPr>
          <p:cNvSpPr txBox="1"/>
          <p:nvPr/>
        </p:nvSpPr>
        <p:spPr>
          <a:xfrm>
            <a:off x="5113877" y="5205365"/>
            <a:ext cx="75854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 i="1">
                <a:latin typeface="Helvetica" pitchFamily="2" charset="0"/>
              </a:rPr>
              <a:t>D. yakuba</a:t>
            </a:r>
          </a:p>
        </p:txBody>
      </p:sp>
      <p:graphicFrame>
        <p:nvGraphicFramePr>
          <p:cNvPr id="22" name="Chart 21">
            <a:extLst>
              <a:ext uri="{FF2B5EF4-FFF2-40B4-BE49-F238E27FC236}">
                <a16:creationId xmlns:a16="http://schemas.microsoft.com/office/drawing/2014/main" id="{7F3762C0-B6D3-3646-B25C-52BDD7C35C0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7604750"/>
              </p:ext>
            </p:extLst>
          </p:nvPr>
        </p:nvGraphicFramePr>
        <p:xfrm>
          <a:off x="299830" y="6753882"/>
          <a:ext cx="3528635" cy="18587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3" name="Chart 22">
            <a:extLst>
              <a:ext uri="{FF2B5EF4-FFF2-40B4-BE49-F238E27FC236}">
                <a16:creationId xmlns:a16="http://schemas.microsoft.com/office/drawing/2014/main" id="{9D33524A-4DC4-DC4A-A98B-2B03D1FDCD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73650944"/>
              </p:ext>
            </p:extLst>
          </p:nvPr>
        </p:nvGraphicFramePr>
        <p:xfrm>
          <a:off x="3664653" y="6753881"/>
          <a:ext cx="3505629" cy="1858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5" name="Chart 24">
            <a:extLst>
              <a:ext uri="{FF2B5EF4-FFF2-40B4-BE49-F238E27FC236}">
                <a16:creationId xmlns:a16="http://schemas.microsoft.com/office/drawing/2014/main" id="{C7516AA8-B1BD-714A-B7A3-F6B63CA929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220042"/>
              </p:ext>
            </p:extLst>
          </p:nvPr>
        </p:nvGraphicFramePr>
        <p:xfrm>
          <a:off x="3664653" y="5134190"/>
          <a:ext cx="3505629" cy="18587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9D76011F-66D8-39FF-626A-2B3F3919C81F}"/>
              </a:ext>
            </a:extLst>
          </p:cNvPr>
          <p:cNvSpPr txBox="1"/>
          <p:nvPr/>
        </p:nvSpPr>
        <p:spPr>
          <a:xfrm rot="16200000">
            <a:off x="-60504" y="9099092"/>
            <a:ext cx="6880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800">
                <a:latin typeface="Helvetica" pitchFamily="2" charset="0"/>
              </a:rPr>
              <a:t>Mean TPM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8E91553-42F3-2169-7A82-47A33FF746C9}"/>
              </a:ext>
            </a:extLst>
          </p:cNvPr>
          <p:cNvSpPr txBox="1"/>
          <p:nvPr/>
        </p:nvSpPr>
        <p:spPr>
          <a:xfrm>
            <a:off x="1505266" y="8692067"/>
            <a:ext cx="9877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 i="1">
                <a:latin typeface="Helvetica" pitchFamily="2" charset="0"/>
              </a:rPr>
              <a:t>D. mojavensi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5A39360-27CF-AD0D-3F05-8961C5883989}"/>
              </a:ext>
            </a:extLst>
          </p:cNvPr>
          <p:cNvSpPr txBox="1"/>
          <p:nvPr/>
        </p:nvSpPr>
        <p:spPr>
          <a:xfrm>
            <a:off x="4972812" y="8696889"/>
            <a:ext cx="98777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JP" sz="1000" i="1">
                <a:latin typeface="Helvetica" pitchFamily="2" charset="0"/>
              </a:rPr>
              <a:t>D. mojavensis</a:t>
            </a:r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F601DE09-77FD-0640-9B5A-C328AA83830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288828"/>
              </p:ext>
            </p:extLst>
          </p:nvPr>
        </p:nvGraphicFramePr>
        <p:xfrm>
          <a:off x="299753" y="8342872"/>
          <a:ext cx="3547838" cy="1863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B4C465DC-D40D-FC40-9ADF-02A106629E4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59675260"/>
              </p:ext>
            </p:extLst>
          </p:nvPr>
        </p:nvGraphicFramePr>
        <p:xfrm>
          <a:off x="3665158" y="8354624"/>
          <a:ext cx="3505124" cy="1863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2173844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800">
            <a:latin typeface="Helvetica" pitchFamily="2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99</TotalTime>
  <Words>41</Words>
  <Application>Microsoft Macintosh PowerPoint</Application>
  <PresentationFormat>Custom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井木　太一郎</dc:creator>
  <cp:lastModifiedBy>井木　太一郎</cp:lastModifiedBy>
  <cp:revision>41</cp:revision>
  <dcterms:created xsi:type="dcterms:W3CDTF">2023-12-19T06:22:29Z</dcterms:created>
  <dcterms:modified xsi:type="dcterms:W3CDTF">2025-07-20T01:09:29Z</dcterms:modified>
</cp:coreProperties>
</file>